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8"/>
  </p:notesMasterIdLst>
  <p:sldIdLst>
    <p:sldId id="258" r:id="rId2"/>
    <p:sldId id="266" r:id="rId3"/>
    <p:sldId id="265" r:id="rId4"/>
    <p:sldId id="261" r:id="rId5"/>
    <p:sldId id="262" r:id="rId6"/>
    <p:sldId id="264" r:id="rId7"/>
  </p:sldIdLst>
  <p:sldSz cx="9753600" cy="7315200"/>
  <p:notesSz cx="6858000" cy="9144000"/>
  <p:embeddedFontLst>
    <p:embeddedFont>
      <p:font typeface="Canva Sans 1 Bold" panose="020B0604020202020204" charset="0"/>
      <p:regular r:id="rId9"/>
    </p:embeddedFont>
    <p:embeddedFont>
      <p:font typeface="DM Sans" pitchFamily="2" charset="0"/>
      <p:regular r:id="rId10"/>
      <p:bold r:id="rId11"/>
      <p:italic r:id="rId12"/>
      <p:boldItalic r:id="rId13"/>
    </p:embeddedFont>
    <p:embeddedFont>
      <p:font typeface="DM Sans Bold" charset="0"/>
      <p:regular r:id="rId14"/>
    </p:embeddedFont>
    <p:embeddedFont>
      <p:font typeface="GSK Precision" pitchFamily="2" charset="0"/>
      <p:regular r:id="rId15"/>
      <p:bold r:id="rId16"/>
      <p:italic r:id="rId17"/>
      <p:boldItalic r:id="rId18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2" autoAdjust="0"/>
  </p:normalViewPr>
  <p:slideViewPr>
    <p:cSldViewPr>
      <p:cViewPr varScale="1">
        <p:scale>
          <a:sx n="62" d="100"/>
          <a:sy n="62" d="100"/>
        </p:scale>
        <p:origin x="408" y="4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font" Target="fonts/font5.fntdata"/><Relationship Id="rId18" Type="http://schemas.openxmlformats.org/officeDocument/2006/relationships/font" Target="fonts/font10.fntdata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font" Target="fonts/font4.fntdata"/><Relationship Id="rId17" Type="http://schemas.openxmlformats.org/officeDocument/2006/relationships/font" Target="fonts/font9.fntdata"/><Relationship Id="rId2" Type="http://schemas.openxmlformats.org/officeDocument/2006/relationships/slide" Target="slides/slide1.xml"/><Relationship Id="rId16" Type="http://schemas.openxmlformats.org/officeDocument/2006/relationships/font" Target="fonts/font8.fntdata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3.fntdata"/><Relationship Id="rId5" Type="http://schemas.openxmlformats.org/officeDocument/2006/relationships/slide" Target="slides/slide4.xml"/><Relationship Id="rId15" Type="http://schemas.openxmlformats.org/officeDocument/2006/relationships/font" Target="fonts/font7.fntdata"/><Relationship Id="rId23" Type="http://schemas.microsoft.com/office/2016/11/relationships/changesInfo" Target="changesInfos/changesInfo1.xml"/><Relationship Id="rId10" Type="http://schemas.openxmlformats.org/officeDocument/2006/relationships/font" Target="fonts/font2.fntdata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font" Target="fonts/font1.fntdata"/><Relationship Id="rId14" Type="http://schemas.openxmlformats.org/officeDocument/2006/relationships/font" Target="fonts/font6.fntdata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ra Bernardi" userId="3bc723f3-b350-4203-a109-bf5b0bd48230" providerId="ADAL" clId="{9D467EC0-1C66-4782-A17B-84D430D256E6}"/>
    <pc:docChg chg="addSld delSld modSld">
      <pc:chgData name="Lara Bernardi" userId="3bc723f3-b350-4203-a109-bf5b0bd48230" providerId="ADAL" clId="{9D467EC0-1C66-4782-A17B-84D430D256E6}" dt="2025-10-15T09:30:20.721" v="1" actId="47"/>
      <pc:docMkLst>
        <pc:docMk/>
      </pc:docMkLst>
      <pc:sldChg chg="add">
        <pc:chgData name="Lara Bernardi" userId="3bc723f3-b350-4203-a109-bf5b0bd48230" providerId="ADAL" clId="{9D467EC0-1C66-4782-A17B-84D430D256E6}" dt="2025-10-15T09:30:18.401" v="0"/>
        <pc:sldMkLst>
          <pc:docMk/>
          <pc:sldMk cId="0" sldId="258"/>
        </pc:sldMkLst>
      </pc:sldChg>
      <pc:sldChg chg="del">
        <pc:chgData name="Lara Bernardi" userId="3bc723f3-b350-4203-a109-bf5b0bd48230" providerId="ADAL" clId="{9D467EC0-1C66-4782-A17B-84D430D256E6}" dt="2025-10-15T09:30:20.721" v="1" actId="47"/>
        <pc:sldMkLst>
          <pc:docMk/>
          <pc:sldMk cId="4015050657" sldId="2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55774A-3DC9-4349-A103-70C1EC08EBEF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A57078-C8F0-4BB0-8007-082F9FC20C0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0310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54C837-30CE-4C99-82DB-273193C65CB3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87686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>
            <a:extLst>
              <a:ext uri="{FF2B5EF4-FFF2-40B4-BE49-F238E27FC236}">
                <a16:creationId xmlns:a16="http://schemas.microsoft.com/office/drawing/2014/main" id="{B3370893-2261-30EB-6BBD-6F8EE159E907}"/>
              </a:ext>
            </a:extLst>
          </p:cNvPr>
          <p:cNvGrpSpPr/>
          <p:nvPr/>
        </p:nvGrpSpPr>
        <p:grpSpPr>
          <a:xfrm>
            <a:off x="5411257" y="3569943"/>
            <a:ext cx="917678" cy="15582"/>
            <a:chOff x="7173066" y="4293274"/>
            <a:chExt cx="1147097" cy="19477"/>
          </a:xfrm>
        </p:grpSpPr>
        <p:sp>
          <p:nvSpPr>
            <p:cNvPr id="20" name="AutoShape 20"/>
            <p:cNvSpPr/>
            <p:nvPr/>
          </p:nvSpPr>
          <p:spPr>
            <a:xfrm flipV="1">
              <a:off x="7173066" y="4297636"/>
              <a:ext cx="904885" cy="2171"/>
            </a:xfrm>
            <a:prstGeom prst="line">
              <a:avLst/>
            </a:prstGeom>
            <a:ln w="142875" cap="rnd">
              <a:solidFill>
                <a:srgbClr val="A66C98"/>
              </a:solidFill>
              <a:prstDash val="solid"/>
              <a:headEnd type="none" w="sm" len="sm"/>
              <a:tailEnd type="none" w="sm" len="sm"/>
            </a:ln>
          </p:spPr>
          <p:txBody>
            <a:bodyPr/>
            <a:lstStyle/>
            <a:p>
              <a:endParaRPr lang="it-IT" sz="1350">
                <a:latin typeface="GSK Precision" pitchFamily="2" charset="0"/>
              </a:endParaRPr>
            </a:p>
          </p:txBody>
        </p:sp>
        <p:sp>
          <p:nvSpPr>
            <p:cNvPr id="36" name="AutoShape 36"/>
            <p:cNvSpPr/>
            <p:nvPr/>
          </p:nvSpPr>
          <p:spPr>
            <a:xfrm flipV="1">
              <a:off x="7231703" y="4293274"/>
              <a:ext cx="1088460" cy="19477"/>
            </a:xfrm>
            <a:prstGeom prst="line">
              <a:avLst/>
            </a:prstGeom>
            <a:ln w="123825" cap="flat">
              <a:solidFill>
                <a:srgbClr val="A66C98"/>
              </a:solidFill>
              <a:prstDash val="solid"/>
              <a:headEnd type="none" w="sm" len="sm"/>
              <a:tailEnd type="triangle" w="lg" len="med"/>
            </a:ln>
          </p:spPr>
          <p:txBody>
            <a:bodyPr/>
            <a:lstStyle/>
            <a:p>
              <a:endParaRPr lang="it-IT" sz="1350">
                <a:latin typeface="GSK Precision" pitchFamily="2" charset="0"/>
              </a:endParaRP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E961982-A6FC-A339-C22E-A8B8A30867D6}"/>
              </a:ext>
            </a:extLst>
          </p:cNvPr>
          <p:cNvGrpSpPr/>
          <p:nvPr/>
        </p:nvGrpSpPr>
        <p:grpSpPr>
          <a:xfrm>
            <a:off x="196170" y="2367546"/>
            <a:ext cx="2068320" cy="2420373"/>
            <a:chOff x="1225717" y="2070688"/>
            <a:chExt cx="2585400" cy="3025466"/>
          </a:xfrm>
        </p:grpSpPr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647EE4CF-87FB-CF62-B005-42FF9CF74A14}"/>
                </a:ext>
              </a:extLst>
            </p:cNvPr>
            <p:cNvGrpSpPr/>
            <p:nvPr/>
          </p:nvGrpSpPr>
          <p:grpSpPr>
            <a:xfrm>
              <a:off x="2649647" y="3562529"/>
              <a:ext cx="1161470" cy="19477"/>
              <a:chOff x="3115810" y="3132028"/>
              <a:chExt cx="1161470" cy="19477"/>
            </a:xfrm>
          </p:grpSpPr>
          <p:sp>
            <p:nvSpPr>
              <p:cNvPr id="19" name="AutoShape 19"/>
              <p:cNvSpPr/>
              <p:nvPr/>
            </p:nvSpPr>
            <p:spPr>
              <a:xfrm flipV="1">
                <a:off x="3115810" y="3138322"/>
                <a:ext cx="904885" cy="2171"/>
              </a:xfrm>
              <a:prstGeom prst="line">
                <a:avLst/>
              </a:prstGeom>
              <a:ln w="142875" cap="rnd">
                <a:solidFill>
                  <a:srgbClr val="6CE5E8"/>
                </a:solidFill>
                <a:prstDash val="solid"/>
                <a:headEnd type="none" w="sm" len="sm"/>
                <a:tailEnd type="none" w="sm" len="sm"/>
              </a:ln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sp>
            <p:nvSpPr>
              <p:cNvPr id="31" name="AutoShape 31"/>
              <p:cNvSpPr/>
              <p:nvPr/>
            </p:nvSpPr>
            <p:spPr>
              <a:xfrm flipV="1">
                <a:off x="3188820" y="3132028"/>
                <a:ext cx="1088460" cy="19477"/>
              </a:xfrm>
              <a:prstGeom prst="line">
                <a:avLst/>
              </a:prstGeom>
              <a:ln w="123825" cap="flat">
                <a:solidFill>
                  <a:srgbClr val="6CE5E8"/>
                </a:solidFill>
                <a:prstDash val="solid"/>
                <a:headEnd type="none" w="sm" len="sm"/>
                <a:tailEnd type="triangle" w="lg" len="med"/>
              </a:ln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5220FA72-43DF-51F4-26E0-12AB96AA80D7}"/>
                </a:ext>
              </a:extLst>
            </p:cNvPr>
            <p:cNvGrpSpPr/>
            <p:nvPr/>
          </p:nvGrpSpPr>
          <p:grpSpPr>
            <a:xfrm>
              <a:off x="1225717" y="2070688"/>
              <a:ext cx="1309573" cy="1306943"/>
              <a:chOff x="1034592" y="3514520"/>
              <a:chExt cx="2201795" cy="2197373"/>
            </a:xfrm>
          </p:grpSpPr>
          <p:sp>
            <p:nvSpPr>
              <p:cNvPr id="42" name="Freeform 3">
                <a:extLst>
                  <a:ext uri="{FF2B5EF4-FFF2-40B4-BE49-F238E27FC236}">
                    <a16:creationId xmlns:a16="http://schemas.microsoft.com/office/drawing/2014/main" id="{59DF9BB4-3163-93CD-D612-D26B90FC5035}"/>
                  </a:ext>
                </a:extLst>
              </p:cNvPr>
              <p:cNvSpPr/>
              <p:nvPr/>
            </p:nvSpPr>
            <p:spPr>
              <a:xfrm>
                <a:off x="1034592" y="3514520"/>
                <a:ext cx="2201795" cy="2197373"/>
              </a:xfrm>
              <a:custGeom>
                <a:avLst/>
                <a:gdLst/>
                <a:ahLst/>
                <a:cxnLst/>
                <a:rect l="l" t="t" r="r" b="b"/>
                <a:pathLst>
                  <a:path w="2348581" h="2343865">
                    <a:moveTo>
                      <a:pt x="0" y="0"/>
                    </a:moveTo>
                    <a:lnTo>
                      <a:pt x="2348581" y="0"/>
                    </a:lnTo>
                    <a:lnTo>
                      <a:pt x="2348581" y="2343866"/>
                    </a:lnTo>
                    <a:lnTo>
                      <a:pt x="0" y="2343866"/>
                    </a:lnTo>
                    <a:lnTo>
                      <a:pt x="0" y="0"/>
                    </a:lnTo>
                    <a:close/>
                  </a:path>
                </a:pathLst>
              </a:custGeom>
              <a:blipFill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grpSp>
            <p:nvGrpSpPr>
              <p:cNvPr id="44" name="Group 15">
                <a:extLst>
                  <a:ext uri="{FF2B5EF4-FFF2-40B4-BE49-F238E27FC236}">
                    <a16:creationId xmlns:a16="http://schemas.microsoft.com/office/drawing/2014/main" id="{1CBF0F22-A2B3-F2B9-B908-02EDB44D8239}"/>
                  </a:ext>
                </a:extLst>
              </p:cNvPr>
              <p:cNvGrpSpPr/>
              <p:nvPr/>
            </p:nvGrpSpPr>
            <p:grpSpPr>
              <a:xfrm>
                <a:off x="1092622" y="3551587"/>
                <a:ext cx="2085735" cy="2085735"/>
                <a:chOff x="0" y="0"/>
                <a:chExt cx="6350000" cy="6350000"/>
              </a:xfrm>
            </p:grpSpPr>
            <p:sp>
              <p:nvSpPr>
                <p:cNvPr id="51" name="Freeform 16">
                  <a:extLst>
                    <a:ext uri="{FF2B5EF4-FFF2-40B4-BE49-F238E27FC236}">
                      <a16:creationId xmlns:a16="http://schemas.microsoft.com/office/drawing/2014/main" id="{4CD33047-2178-44D7-8655-FB85E54339A7}"/>
                    </a:ext>
                  </a:extLst>
                </p:cNvPr>
                <p:cNvSpPr/>
                <p:nvPr/>
              </p:nvSpPr>
              <p:spPr>
                <a:xfrm>
                  <a:off x="0" y="0"/>
                  <a:ext cx="6350000" cy="6350000"/>
                </a:xfrm>
                <a:prstGeom prst="roundRect">
                  <a:avLst/>
                </a:prstGeom>
                <a:solidFill>
                  <a:srgbClr val="FFFFFF"/>
                </a:solidFill>
                <a:ln w="38100">
                  <a:solidFill>
                    <a:srgbClr val="6CE5E8"/>
                  </a:solidFill>
                </a:ln>
              </p:spPr>
              <p:txBody>
                <a:bodyPr/>
                <a:lstStyle/>
                <a:p>
                  <a:endParaRPr lang="it-IT" sz="1350" dirty="0">
                    <a:latin typeface="GSK Precision" pitchFamily="2" charset="0"/>
                  </a:endParaRPr>
                </a:p>
              </p:txBody>
            </p:sp>
          </p:grpSp>
          <p:sp>
            <p:nvSpPr>
              <p:cNvPr id="46" name="Freeform 21">
                <a:extLst>
                  <a:ext uri="{FF2B5EF4-FFF2-40B4-BE49-F238E27FC236}">
                    <a16:creationId xmlns:a16="http://schemas.microsoft.com/office/drawing/2014/main" id="{C98C8FE1-6D5B-8E95-00FD-7C8699017A6F}"/>
                  </a:ext>
                </a:extLst>
              </p:cNvPr>
              <p:cNvSpPr/>
              <p:nvPr/>
            </p:nvSpPr>
            <p:spPr>
              <a:xfrm>
                <a:off x="1459960" y="3823441"/>
                <a:ext cx="565100" cy="305153"/>
              </a:xfrm>
              <a:custGeom>
                <a:avLst/>
                <a:gdLst/>
                <a:ahLst/>
                <a:cxnLst/>
                <a:rect l="l" t="t" r="r" b="b"/>
                <a:pathLst>
                  <a:path w="602773" h="325497">
                    <a:moveTo>
                      <a:pt x="0" y="0"/>
                    </a:moveTo>
                    <a:lnTo>
                      <a:pt x="602773" y="0"/>
                    </a:lnTo>
                    <a:lnTo>
                      <a:pt x="602773" y="325498"/>
                    </a:lnTo>
                    <a:lnTo>
                      <a:pt x="0" y="325498"/>
                    </a:lnTo>
                    <a:lnTo>
                      <a:pt x="0" y="0"/>
                    </a:lnTo>
                    <a:close/>
                  </a:path>
                </a:pathLst>
              </a:custGeom>
              <a:blipFill>
                <a:blip r:embed="rId4">
                  <a:extLst>
                    <a:ext uri="{96DAC541-7B7A-43D3-8B79-37D633B846F1}">
                      <asvg:svgBlip xmlns:asvg="http://schemas.microsoft.com/office/drawing/2016/SVG/main" r:embed="rId5"/>
                    </a:ext>
                  </a:extLst>
                </a:blip>
                <a:stretch>
                  <a:fillRect/>
                </a:stretch>
              </a:blipFill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sp>
            <p:nvSpPr>
              <p:cNvPr id="48" name="Freeform 23">
                <a:extLst>
                  <a:ext uri="{FF2B5EF4-FFF2-40B4-BE49-F238E27FC236}">
                    <a16:creationId xmlns:a16="http://schemas.microsoft.com/office/drawing/2014/main" id="{5CCCB3A8-7671-B1B1-6FEB-9171418C2A1F}"/>
                  </a:ext>
                </a:extLst>
              </p:cNvPr>
              <p:cNvSpPr/>
              <p:nvPr/>
            </p:nvSpPr>
            <p:spPr>
              <a:xfrm>
                <a:off x="2232213" y="3823441"/>
                <a:ext cx="565100" cy="305153"/>
              </a:xfrm>
              <a:custGeom>
                <a:avLst/>
                <a:gdLst/>
                <a:ahLst/>
                <a:cxnLst/>
                <a:rect l="l" t="t" r="r" b="b"/>
                <a:pathLst>
                  <a:path w="602773" h="325497">
                    <a:moveTo>
                      <a:pt x="0" y="0"/>
                    </a:moveTo>
                    <a:lnTo>
                      <a:pt x="602773" y="0"/>
                    </a:lnTo>
                    <a:lnTo>
                      <a:pt x="602773" y="325498"/>
                    </a:lnTo>
                    <a:lnTo>
                      <a:pt x="0" y="325498"/>
                    </a:lnTo>
                    <a:lnTo>
                      <a:pt x="0" y="0"/>
                    </a:lnTo>
                    <a:close/>
                  </a:path>
                </a:pathLst>
              </a:custGeom>
              <a:blipFill>
                <a:blip r:embed="rId4">
                  <a:extLst>
                    <a:ext uri="{96DAC541-7B7A-43D3-8B79-37D633B846F1}">
                      <asvg:svgBlip xmlns:asvg="http://schemas.microsoft.com/office/drawing/2016/SVG/main" r:embed="rId5"/>
                    </a:ext>
                  </a:extLst>
                </a:blip>
                <a:stretch>
                  <a:fillRect/>
                </a:stretch>
              </a:blipFill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sp>
            <p:nvSpPr>
              <p:cNvPr id="50" name="TextBox 39">
                <a:extLst>
                  <a:ext uri="{FF2B5EF4-FFF2-40B4-BE49-F238E27FC236}">
                    <a16:creationId xmlns:a16="http://schemas.microsoft.com/office/drawing/2014/main" id="{9C3EDD23-8018-F3BE-B2BA-6852FF5E7E47}"/>
                  </a:ext>
                </a:extLst>
              </p:cNvPr>
              <p:cNvSpPr txBox="1"/>
              <p:nvPr/>
            </p:nvSpPr>
            <p:spPr>
              <a:xfrm>
                <a:off x="1058588" y="4214640"/>
                <a:ext cx="2153800" cy="1252972"/>
              </a:xfrm>
              <a:prstGeom prst="rect">
                <a:avLst/>
              </a:prstGeom>
            </p:spPr>
            <p:txBody>
              <a:bodyPr lIns="0" tIns="0" rIns="0" bIns="0" rtlCol="0" anchor="t">
                <a:spAutoFit/>
              </a:bodyPr>
              <a:lstStyle/>
              <a:p>
                <a:pPr algn="ctr">
                  <a:lnSpc>
                    <a:spcPts val="1615"/>
                  </a:lnSpc>
                </a:pPr>
                <a:r>
                  <a:rPr lang="en-US" sz="1154" dirty="0">
                    <a:latin typeface="GSK Precision" pitchFamily="2" charset="0"/>
                    <a:ea typeface="Inter Bold"/>
                    <a:cs typeface="Inter Bold"/>
                    <a:sym typeface="Inter Bold"/>
                  </a:rPr>
                  <a:t>Focus </a:t>
                </a:r>
              </a:p>
              <a:p>
                <a:pPr algn="ctr">
                  <a:lnSpc>
                    <a:spcPts val="1615"/>
                  </a:lnSpc>
                </a:pPr>
                <a:r>
                  <a:rPr lang="en-US" sz="1154" dirty="0">
                    <a:latin typeface="GSK Precision" pitchFamily="2" charset="0"/>
                    <a:ea typeface="Inter Bold"/>
                    <a:cs typeface="Inter Bold"/>
                    <a:sym typeface="Inter Bold"/>
                  </a:rPr>
                  <a:t>group 1 (6 patients)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F47D78DB-9FF9-E9E8-F387-AE2721D0EF0E}"/>
                </a:ext>
              </a:extLst>
            </p:cNvPr>
            <p:cNvGrpSpPr/>
            <p:nvPr/>
          </p:nvGrpSpPr>
          <p:grpSpPr>
            <a:xfrm>
              <a:off x="1261133" y="3789211"/>
              <a:ext cx="1309573" cy="1306943"/>
              <a:chOff x="1034592" y="3514520"/>
              <a:chExt cx="2201795" cy="2197373"/>
            </a:xfrm>
          </p:grpSpPr>
          <p:sp>
            <p:nvSpPr>
              <p:cNvPr id="89" name="Freeform 3">
                <a:extLst>
                  <a:ext uri="{FF2B5EF4-FFF2-40B4-BE49-F238E27FC236}">
                    <a16:creationId xmlns:a16="http://schemas.microsoft.com/office/drawing/2014/main" id="{FDF6AABE-F378-6C84-F565-4836F6A8A97C}"/>
                  </a:ext>
                </a:extLst>
              </p:cNvPr>
              <p:cNvSpPr/>
              <p:nvPr/>
            </p:nvSpPr>
            <p:spPr>
              <a:xfrm>
                <a:off x="1034592" y="3514520"/>
                <a:ext cx="2201795" cy="2197373"/>
              </a:xfrm>
              <a:custGeom>
                <a:avLst/>
                <a:gdLst/>
                <a:ahLst/>
                <a:cxnLst/>
                <a:rect l="l" t="t" r="r" b="b"/>
                <a:pathLst>
                  <a:path w="2348581" h="2343865">
                    <a:moveTo>
                      <a:pt x="0" y="0"/>
                    </a:moveTo>
                    <a:lnTo>
                      <a:pt x="2348581" y="0"/>
                    </a:lnTo>
                    <a:lnTo>
                      <a:pt x="2348581" y="2343866"/>
                    </a:lnTo>
                    <a:lnTo>
                      <a:pt x="0" y="2343866"/>
                    </a:lnTo>
                    <a:lnTo>
                      <a:pt x="0" y="0"/>
                    </a:lnTo>
                    <a:close/>
                  </a:path>
                </a:pathLst>
              </a:custGeom>
              <a:blipFill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grpSp>
            <p:nvGrpSpPr>
              <p:cNvPr id="91" name="Group 15">
                <a:extLst>
                  <a:ext uri="{FF2B5EF4-FFF2-40B4-BE49-F238E27FC236}">
                    <a16:creationId xmlns:a16="http://schemas.microsoft.com/office/drawing/2014/main" id="{CCDD8A35-6D4D-96C2-9DAC-CA1A90956143}"/>
                  </a:ext>
                </a:extLst>
              </p:cNvPr>
              <p:cNvGrpSpPr/>
              <p:nvPr/>
            </p:nvGrpSpPr>
            <p:grpSpPr>
              <a:xfrm>
                <a:off x="1092622" y="3551587"/>
                <a:ext cx="2085735" cy="2085735"/>
                <a:chOff x="0" y="0"/>
                <a:chExt cx="6350000" cy="6350000"/>
              </a:xfrm>
            </p:grpSpPr>
            <p:sp>
              <p:nvSpPr>
                <p:cNvPr id="96" name="Freeform 16">
                  <a:extLst>
                    <a:ext uri="{FF2B5EF4-FFF2-40B4-BE49-F238E27FC236}">
                      <a16:creationId xmlns:a16="http://schemas.microsoft.com/office/drawing/2014/main" id="{B0DAA939-04BC-C038-6A57-C01CA21EF16A}"/>
                    </a:ext>
                  </a:extLst>
                </p:cNvPr>
                <p:cNvSpPr/>
                <p:nvPr/>
              </p:nvSpPr>
              <p:spPr>
                <a:xfrm>
                  <a:off x="0" y="0"/>
                  <a:ext cx="6350000" cy="6350000"/>
                </a:xfrm>
                <a:prstGeom prst="roundRect">
                  <a:avLst/>
                </a:prstGeom>
                <a:solidFill>
                  <a:srgbClr val="FFFFFF"/>
                </a:solidFill>
                <a:ln w="38100">
                  <a:solidFill>
                    <a:srgbClr val="6CE5E8"/>
                  </a:solidFill>
                </a:ln>
              </p:spPr>
              <p:txBody>
                <a:bodyPr/>
                <a:lstStyle/>
                <a:p>
                  <a:endParaRPr lang="it-IT" sz="1350">
                    <a:latin typeface="GSK Precision" pitchFamily="2" charset="0"/>
                  </a:endParaRPr>
                </a:p>
              </p:txBody>
            </p:sp>
          </p:grpSp>
          <p:sp>
            <p:nvSpPr>
              <p:cNvPr id="93" name="Freeform 21">
                <a:extLst>
                  <a:ext uri="{FF2B5EF4-FFF2-40B4-BE49-F238E27FC236}">
                    <a16:creationId xmlns:a16="http://schemas.microsoft.com/office/drawing/2014/main" id="{19B20354-3032-F8AE-DEC0-D7F46A5933E1}"/>
                  </a:ext>
                </a:extLst>
              </p:cNvPr>
              <p:cNvSpPr/>
              <p:nvPr/>
            </p:nvSpPr>
            <p:spPr>
              <a:xfrm>
                <a:off x="1459960" y="3823441"/>
                <a:ext cx="565100" cy="305153"/>
              </a:xfrm>
              <a:custGeom>
                <a:avLst/>
                <a:gdLst/>
                <a:ahLst/>
                <a:cxnLst/>
                <a:rect l="l" t="t" r="r" b="b"/>
                <a:pathLst>
                  <a:path w="602773" h="325497">
                    <a:moveTo>
                      <a:pt x="0" y="0"/>
                    </a:moveTo>
                    <a:lnTo>
                      <a:pt x="602773" y="0"/>
                    </a:lnTo>
                    <a:lnTo>
                      <a:pt x="602773" y="325498"/>
                    </a:lnTo>
                    <a:lnTo>
                      <a:pt x="0" y="325498"/>
                    </a:lnTo>
                    <a:lnTo>
                      <a:pt x="0" y="0"/>
                    </a:lnTo>
                    <a:close/>
                  </a:path>
                </a:pathLst>
              </a:custGeom>
              <a:blipFill>
                <a:blip r:embed="rId4">
                  <a:extLst>
                    <a:ext uri="{96DAC541-7B7A-43D3-8B79-37D633B846F1}">
                      <asvg:svgBlip xmlns:asvg="http://schemas.microsoft.com/office/drawing/2016/SVG/main" r:embed="rId5"/>
                    </a:ext>
                  </a:extLst>
                </a:blip>
                <a:stretch>
                  <a:fillRect/>
                </a:stretch>
              </a:blipFill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sp>
            <p:nvSpPr>
              <p:cNvPr id="94" name="Freeform 23">
                <a:extLst>
                  <a:ext uri="{FF2B5EF4-FFF2-40B4-BE49-F238E27FC236}">
                    <a16:creationId xmlns:a16="http://schemas.microsoft.com/office/drawing/2014/main" id="{A679B085-ED16-C8DD-DA4D-162212D33C09}"/>
                  </a:ext>
                </a:extLst>
              </p:cNvPr>
              <p:cNvSpPr/>
              <p:nvPr/>
            </p:nvSpPr>
            <p:spPr>
              <a:xfrm>
                <a:off x="2232213" y="3823441"/>
                <a:ext cx="565100" cy="305153"/>
              </a:xfrm>
              <a:custGeom>
                <a:avLst/>
                <a:gdLst/>
                <a:ahLst/>
                <a:cxnLst/>
                <a:rect l="l" t="t" r="r" b="b"/>
                <a:pathLst>
                  <a:path w="602773" h="325497">
                    <a:moveTo>
                      <a:pt x="0" y="0"/>
                    </a:moveTo>
                    <a:lnTo>
                      <a:pt x="602773" y="0"/>
                    </a:lnTo>
                    <a:lnTo>
                      <a:pt x="602773" y="325498"/>
                    </a:lnTo>
                    <a:lnTo>
                      <a:pt x="0" y="325498"/>
                    </a:lnTo>
                    <a:lnTo>
                      <a:pt x="0" y="0"/>
                    </a:lnTo>
                    <a:close/>
                  </a:path>
                </a:pathLst>
              </a:custGeom>
              <a:blipFill>
                <a:blip r:embed="rId4">
                  <a:extLst>
                    <a:ext uri="{96DAC541-7B7A-43D3-8B79-37D633B846F1}">
                      <asvg:svgBlip xmlns:asvg="http://schemas.microsoft.com/office/drawing/2016/SVG/main" r:embed="rId5"/>
                    </a:ext>
                  </a:extLst>
                </a:blip>
                <a:stretch>
                  <a:fillRect/>
                </a:stretch>
              </a:blipFill>
            </p:spPr>
            <p:txBody>
              <a:bodyPr/>
              <a:lstStyle/>
              <a:p>
                <a:endParaRPr lang="it-IT" sz="1350">
                  <a:latin typeface="GSK Precision" pitchFamily="2" charset="0"/>
                </a:endParaRPr>
              </a:p>
            </p:txBody>
          </p:sp>
          <p:sp>
            <p:nvSpPr>
              <p:cNvPr id="95" name="TextBox 39">
                <a:extLst>
                  <a:ext uri="{FF2B5EF4-FFF2-40B4-BE49-F238E27FC236}">
                    <a16:creationId xmlns:a16="http://schemas.microsoft.com/office/drawing/2014/main" id="{58D6ACDF-4C04-5C44-0408-413E0E4C1619}"/>
                  </a:ext>
                </a:extLst>
              </p:cNvPr>
              <p:cNvSpPr txBox="1"/>
              <p:nvPr/>
            </p:nvSpPr>
            <p:spPr>
              <a:xfrm>
                <a:off x="1058588" y="4233204"/>
                <a:ext cx="2153800" cy="1252972"/>
              </a:xfrm>
              <a:prstGeom prst="rect">
                <a:avLst/>
              </a:prstGeom>
            </p:spPr>
            <p:txBody>
              <a:bodyPr lIns="0" tIns="0" rIns="0" bIns="0" rtlCol="0" anchor="t">
                <a:spAutoFit/>
              </a:bodyPr>
              <a:lstStyle/>
              <a:p>
                <a:pPr algn="ctr">
                  <a:lnSpc>
                    <a:spcPts val="1615"/>
                  </a:lnSpc>
                </a:pPr>
                <a:r>
                  <a:rPr lang="en-US" sz="1154" dirty="0">
                    <a:latin typeface="GSK Precision" pitchFamily="2" charset="0"/>
                    <a:ea typeface="Inter Bold"/>
                    <a:cs typeface="Inter Bold"/>
                    <a:sym typeface="Inter Bold"/>
                  </a:rPr>
                  <a:t>Focus </a:t>
                </a:r>
              </a:p>
              <a:p>
                <a:pPr algn="ctr">
                  <a:lnSpc>
                    <a:spcPts val="1615"/>
                  </a:lnSpc>
                </a:pPr>
                <a:r>
                  <a:rPr lang="en-US" sz="1154" dirty="0">
                    <a:latin typeface="GSK Precision" pitchFamily="2" charset="0"/>
                    <a:ea typeface="Inter Bold"/>
                    <a:cs typeface="Inter Bold"/>
                    <a:sym typeface="Inter Bold"/>
                  </a:rPr>
                  <a:t>group 2 (6 patients) 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9F8DC0C6-C1E6-64DD-089A-AF1FD97332A7}"/>
              </a:ext>
            </a:extLst>
          </p:cNvPr>
          <p:cNvGrpSpPr/>
          <p:nvPr/>
        </p:nvGrpSpPr>
        <p:grpSpPr>
          <a:xfrm>
            <a:off x="2541874" y="1978641"/>
            <a:ext cx="2592000" cy="3218616"/>
            <a:chOff x="2830612" y="1831611"/>
            <a:chExt cx="3240000" cy="402327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304DEB5-83DE-224B-568A-08295D9BD683}"/>
                </a:ext>
              </a:extLst>
            </p:cNvPr>
            <p:cNvSpPr txBox="1"/>
            <p:nvPr/>
          </p:nvSpPr>
          <p:spPr>
            <a:xfrm>
              <a:off x="2830612" y="2654607"/>
              <a:ext cx="3240000" cy="1966496"/>
            </a:xfrm>
            <a:prstGeom prst="roundRect">
              <a:avLst/>
            </a:prstGeom>
            <a:noFill/>
            <a:ln w="57150">
              <a:solidFill>
                <a:srgbClr val="A66C98"/>
              </a:solidFill>
            </a:ln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  <p:txBody>
            <a:bodyPr wrap="square" rtlCol="0">
              <a:spAutoFit/>
            </a:bodyPr>
            <a:lstStyle/>
            <a:p>
              <a:pPr marL="228600" indent="-228600">
                <a:buFont typeface="Arial" panose="020B0604020202020204" pitchFamily="34" charset="0"/>
                <a:buChar char="•"/>
              </a:pPr>
              <a:r>
                <a:rPr lang="it-IT" sz="1440" dirty="0">
                  <a:latin typeface="GSK Precision" pitchFamily="2" charset="0"/>
                </a:rPr>
                <a:t>3 HCPs (allergist, ENT, pulmunologist) </a:t>
              </a:r>
            </a:p>
            <a:p>
              <a:pPr marL="228600" indent="-228600">
                <a:buFont typeface="Arial" panose="020B0604020202020204" pitchFamily="34" charset="0"/>
                <a:buChar char="•"/>
              </a:pPr>
              <a:r>
                <a:rPr lang="it-IT" sz="1440" dirty="0">
                  <a:latin typeface="GSK Precision" pitchFamily="2" charset="0"/>
                </a:rPr>
                <a:t>8 Patients from Respiriamo insieme APS</a:t>
              </a:r>
            </a:p>
            <a:p>
              <a:pPr marL="228600" indent="-228600">
                <a:buFont typeface="Arial" panose="020B0604020202020204" pitchFamily="34" charset="0"/>
                <a:buChar char="•"/>
              </a:pPr>
              <a:r>
                <a:rPr lang="it-IT" sz="1440" dirty="0">
                  <a:latin typeface="GSK Precision" pitchFamily="2" charset="0"/>
                </a:rPr>
                <a:t>PAG President</a:t>
              </a:r>
            </a:p>
            <a:p>
              <a:pPr marL="228600" indent="-228600">
                <a:buFont typeface="Arial" panose="020B0604020202020204" pitchFamily="34" charset="0"/>
                <a:buChar char="•"/>
              </a:pPr>
              <a:endParaRPr lang="it-IT" sz="1440" dirty="0">
                <a:latin typeface="GSK Precision" pitchFamily="2" charset="0"/>
              </a:endParaRPr>
            </a:p>
          </p:txBody>
        </p:sp>
        <p:sp>
          <p:nvSpPr>
            <p:cNvPr id="17" name="Subtitle 2">
              <a:extLst>
                <a:ext uri="{FF2B5EF4-FFF2-40B4-BE49-F238E27FC236}">
                  <a16:creationId xmlns:a16="http://schemas.microsoft.com/office/drawing/2014/main" id="{26235880-A6CE-F63B-99AA-07CC798307F3}"/>
                </a:ext>
              </a:extLst>
            </p:cNvPr>
            <p:cNvSpPr txBox="1">
              <a:spLocks/>
            </p:cNvSpPr>
            <p:nvPr/>
          </p:nvSpPr>
          <p:spPr>
            <a:xfrm>
              <a:off x="2830612" y="1831611"/>
              <a:ext cx="3240000" cy="610775"/>
            </a:xfrm>
            <a:prstGeom prst="roundRect">
              <a:avLst/>
            </a:prstGeom>
            <a:solidFill>
              <a:srgbClr val="A66C98"/>
            </a:solidFill>
            <a:ln w="38100">
              <a:solidFill>
                <a:srgbClr val="A66C98"/>
              </a:solidFill>
            </a:ln>
          </p:spPr>
          <p:txBody>
            <a:bodyPr>
              <a:norm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it-IT" sz="2240" dirty="0">
                  <a:latin typeface="GSK Precision" pitchFamily="2" charset="0"/>
                </a:rPr>
                <a:t>Expert board 1: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32B4140-ADAB-340D-85FA-2C9DBF0EEAE1}"/>
                </a:ext>
              </a:extLst>
            </p:cNvPr>
            <p:cNvSpPr txBox="1"/>
            <p:nvPr/>
          </p:nvSpPr>
          <p:spPr>
            <a:xfrm>
              <a:off x="2830612" y="4807786"/>
              <a:ext cx="3240000" cy="1047095"/>
            </a:xfrm>
            <a:prstGeom prst="roundRect">
              <a:avLst/>
            </a:prstGeom>
            <a:solidFill>
              <a:srgbClr val="A66C98"/>
            </a:solidFill>
            <a:ln>
              <a:solidFill>
                <a:srgbClr val="A66C98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440" dirty="0">
                  <a:solidFill>
                    <a:schemeClr val="bg1"/>
                  </a:solidFill>
                  <a:latin typeface="GSK Precision" pitchFamily="2" charset="0"/>
                </a:rPr>
                <a:t>Patient insights collection going on through expert patients’ narration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8379FA18-F606-3B85-A13D-5C9367BE768F}"/>
              </a:ext>
            </a:extLst>
          </p:cNvPr>
          <p:cNvGrpSpPr/>
          <p:nvPr/>
        </p:nvGrpSpPr>
        <p:grpSpPr>
          <a:xfrm>
            <a:off x="6606318" y="1979390"/>
            <a:ext cx="2592002" cy="3217119"/>
            <a:chOff x="7645640" y="1368211"/>
            <a:chExt cx="3240002" cy="4021399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68E20F9-8210-C00C-804D-E83F734272B3}"/>
                </a:ext>
              </a:extLst>
            </p:cNvPr>
            <p:cNvSpPr txBox="1"/>
            <p:nvPr/>
          </p:nvSpPr>
          <p:spPr>
            <a:xfrm>
              <a:off x="7645642" y="2193443"/>
              <a:ext cx="3240000" cy="1966496"/>
            </a:xfrm>
            <a:prstGeom prst="roundRect">
              <a:avLst/>
            </a:prstGeom>
            <a:noFill/>
            <a:ln w="57150">
              <a:solidFill>
                <a:srgbClr val="42B8D5"/>
              </a:solidFill>
            </a:ln>
            <a:effectLst>
              <a:outerShdw blurRad="50800" dist="38100" dir="5400000" algn="t" rotWithShape="0">
                <a:prstClr val="black">
                  <a:alpha val="40000"/>
                </a:prstClr>
              </a:outerShdw>
            </a:effectLst>
          </p:spPr>
          <p:txBody>
            <a:bodyPr wrap="square" rtlCol="0">
              <a:spAutoFit/>
            </a:bodyPr>
            <a:lstStyle/>
            <a:p>
              <a:pPr marL="228600" indent="-228600">
                <a:buFont typeface="Arial" panose="020B0604020202020204" pitchFamily="34" charset="0"/>
                <a:buChar char="•"/>
              </a:pPr>
              <a:r>
                <a:rPr lang="it-IT" sz="1440" dirty="0">
                  <a:latin typeface="GSK Precision" pitchFamily="2" charset="0"/>
                </a:rPr>
                <a:t>3 HCPs (allergist, psychologist, pulmunologist) </a:t>
              </a:r>
            </a:p>
            <a:p>
              <a:pPr marL="228600" indent="-228600">
                <a:buFont typeface="Arial" panose="020B0604020202020204" pitchFamily="34" charset="0"/>
                <a:buChar char="•"/>
              </a:pPr>
              <a:r>
                <a:rPr lang="it-IT" sz="1440" dirty="0">
                  <a:latin typeface="GSK Precision" pitchFamily="2" charset="0"/>
                </a:rPr>
                <a:t>4 Patients from Respiriamo insieme APS </a:t>
              </a:r>
            </a:p>
            <a:p>
              <a:pPr marL="228600" indent="-228600">
                <a:buFont typeface="Arial" panose="020B0604020202020204" pitchFamily="34" charset="0"/>
                <a:buChar char="•"/>
              </a:pPr>
              <a:r>
                <a:rPr lang="it-IT" sz="1440" dirty="0">
                  <a:latin typeface="GSK Precision" pitchFamily="2" charset="0"/>
                </a:rPr>
                <a:t>PAG President</a:t>
              </a:r>
            </a:p>
          </p:txBody>
        </p:sp>
        <p:sp>
          <p:nvSpPr>
            <p:cNvPr id="18" name="Subtitle 2">
              <a:extLst>
                <a:ext uri="{FF2B5EF4-FFF2-40B4-BE49-F238E27FC236}">
                  <a16:creationId xmlns:a16="http://schemas.microsoft.com/office/drawing/2014/main" id="{2AD4BE14-33B0-F6F5-3391-E4FF7C36996E}"/>
                </a:ext>
              </a:extLst>
            </p:cNvPr>
            <p:cNvSpPr txBox="1">
              <a:spLocks/>
            </p:cNvSpPr>
            <p:nvPr/>
          </p:nvSpPr>
          <p:spPr>
            <a:xfrm>
              <a:off x="7645641" y="1368211"/>
              <a:ext cx="3240000" cy="610775"/>
            </a:xfrm>
            <a:prstGeom prst="roundRect">
              <a:avLst/>
            </a:prstGeom>
            <a:solidFill>
              <a:srgbClr val="42B8D5"/>
            </a:solidFill>
            <a:ln w="38100">
              <a:solidFill>
                <a:srgbClr val="42B8D5"/>
              </a:solidFill>
            </a:ln>
          </p:spPr>
          <p:txBody>
            <a:bodyPr>
              <a:norm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it-IT" sz="2240" dirty="0">
                  <a:latin typeface="GSK Precision" pitchFamily="2" charset="0"/>
                </a:rPr>
                <a:t>Expert board 2: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EC9A7B2-B106-4587-75D4-1B191AB09EB0}"/>
                </a:ext>
              </a:extLst>
            </p:cNvPr>
            <p:cNvSpPr txBox="1"/>
            <p:nvPr/>
          </p:nvSpPr>
          <p:spPr>
            <a:xfrm>
              <a:off x="7645640" y="4342515"/>
              <a:ext cx="3240000" cy="1047095"/>
            </a:xfrm>
            <a:prstGeom prst="roundRect">
              <a:avLst/>
            </a:prstGeom>
            <a:solidFill>
              <a:srgbClr val="42B8D5"/>
            </a:solidFill>
            <a:ln>
              <a:solidFill>
                <a:srgbClr val="42B8D5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440" dirty="0">
                  <a:solidFill>
                    <a:schemeClr val="bg1"/>
                  </a:solidFill>
                  <a:latin typeface="GSK Precision" pitchFamily="2" charset="0"/>
                </a:rPr>
                <a:t>Patient insights collection going on through expert patients’ narration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CF4E072-6CCC-D3A1-DF5E-5C519BDDF4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7695898"/>
              </p:ext>
            </p:extLst>
          </p:nvPr>
        </p:nvGraphicFramePr>
        <p:xfrm>
          <a:off x="1447800" y="1066800"/>
          <a:ext cx="6629400" cy="487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64614">
                  <a:extLst>
                    <a:ext uri="{9D8B030D-6E8A-4147-A177-3AD203B41FA5}">
                      <a16:colId xmlns:a16="http://schemas.microsoft.com/office/drawing/2014/main" val="1899990591"/>
                    </a:ext>
                  </a:extLst>
                </a:gridCol>
                <a:gridCol w="3064786">
                  <a:extLst>
                    <a:ext uri="{9D8B030D-6E8A-4147-A177-3AD203B41FA5}">
                      <a16:colId xmlns:a16="http://schemas.microsoft.com/office/drawing/2014/main" val="2859426225"/>
                    </a:ext>
                  </a:extLst>
                </a:gridCol>
              </a:tblGrid>
              <a:tr h="9753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Sample (N = 24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extLst>
                  <a:ext uri="{0D108BD9-81ED-4DB2-BD59-A6C34878D82A}">
                    <a16:rowId xmlns:a16="http://schemas.microsoft.com/office/drawing/2014/main" val="2343934383"/>
                  </a:ext>
                </a:extLst>
              </a:tr>
              <a:tr h="9753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Female (%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42% (N=10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extLst>
                  <a:ext uri="{0D108BD9-81ED-4DB2-BD59-A6C34878D82A}">
                    <a16:rowId xmlns:a16="http://schemas.microsoft.com/office/drawing/2014/main" val="693982058"/>
                  </a:ext>
                </a:extLst>
              </a:tr>
              <a:tr h="9753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Male (%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58% (N=14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extLst>
                  <a:ext uri="{0D108BD9-81ED-4DB2-BD59-A6C34878D82A}">
                    <a16:rowId xmlns:a16="http://schemas.microsoft.com/office/drawing/2014/main" val="1795409955"/>
                  </a:ext>
                </a:extLst>
              </a:tr>
              <a:tr h="9753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Age (range)​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28-70​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extLst>
                  <a:ext uri="{0D108BD9-81ED-4DB2-BD59-A6C34878D82A}">
                    <a16:rowId xmlns:a16="http://schemas.microsoft.com/office/drawing/2014/main" val="189268860"/>
                  </a:ext>
                </a:extLst>
              </a:tr>
              <a:tr h="97536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>
                          <a:effectLst/>
                        </a:rPr>
                        <a:t>Age (mean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200" dirty="0">
                          <a:effectLst/>
                        </a:rPr>
                        <a:t>49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39700" marR="139700" marT="139700" marB="139700" anchor="ctr"/>
                </a:tc>
                <a:extLst>
                  <a:ext uri="{0D108BD9-81ED-4DB2-BD59-A6C34878D82A}">
                    <a16:rowId xmlns:a16="http://schemas.microsoft.com/office/drawing/2014/main" val="1987556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7811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6A439EF-1271-6112-E42A-501DD4B693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0784958"/>
              </p:ext>
            </p:extLst>
          </p:nvPr>
        </p:nvGraphicFramePr>
        <p:xfrm>
          <a:off x="685800" y="1295400"/>
          <a:ext cx="8001000" cy="4343398"/>
        </p:xfrm>
        <a:graphic>
          <a:graphicData uri="http://schemas.openxmlformats.org/drawingml/2006/table">
            <a:tbl>
              <a:tblPr firstRow="1" firstCol="1" bandRow="1"/>
              <a:tblGrid>
                <a:gridCol w="4000500">
                  <a:extLst>
                    <a:ext uri="{9D8B030D-6E8A-4147-A177-3AD203B41FA5}">
                      <a16:colId xmlns:a16="http://schemas.microsoft.com/office/drawing/2014/main" val="288633952"/>
                    </a:ext>
                  </a:extLst>
                </a:gridCol>
                <a:gridCol w="4000500">
                  <a:extLst>
                    <a:ext uri="{9D8B030D-6E8A-4147-A177-3AD203B41FA5}">
                      <a16:colId xmlns:a16="http://schemas.microsoft.com/office/drawing/2014/main" val="3278255173"/>
                    </a:ext>
                  </a:extLst>
                </a:gridCol>
              </a:tblGrid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b="1" dirty="0"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tient perspective (most → least cited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b="1"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hysician perspective (most → least cited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831969"/>
                  </a:ext>
                </a:extLst>
              </a:tr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b="1">
                          <a:solidFill>
                            <a:srgbClr val="FFFFFF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 Reducing the need for surgery 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E396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>
                          <a:solidFill>
                            <a:srgbClr val="FFFFFF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 Reducing the need for surgery 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E396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536207"/>
                  </a:ext>
                </a:extLst>
              </a:tr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it-IT" sz="1200" b="1">
                          <a:solidFill>
                            <a:srgbClr val="FFFFFF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 Avoiding chronicity / reducing relapse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1356E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>
                          <a:solidFill>
                            <a:srgbClr val="FFFFFF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 Preventing relapses and reducing disease burde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1356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4585086"/>
                  </a:ext>
                </a:extLst>
              </a:tr>
              <a:tr h="98243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 Being heard and having more opportunities to communicate with HCP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F98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 Greater adherence to pharmacological therapie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F5F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948107"/>
                  </a:ext>
                </a:extLst>
              </a:tr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 Impact on quality of life (fatigue, anosmia, emotional burden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D8BBA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 Quality of life impact and functional limitation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D8BB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7460339"/>
                  </a:ext>
                </a:extLst>
              </a:tr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it-IT" sz="1200" b="1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 Access to personalized treatmen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B8D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 Need for personalized treatment strategies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1B8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111984"/>
                  </a:ext>
                </a:extLst>
              </a:tr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it-IT" sz="1200" b="1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 Psychological / emotional support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CE5E8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it-IT" sz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 Improved multidisciplinary coordination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CE5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4364976"/>
                  </a:ext>
                </a:extLst>
              </a:tr>
              <a:tr h="4801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 Clearer information on the care pathway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F4F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 Patient education and the role of PAGs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F4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43426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896686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2F2F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14138" y="895409"/>
            <a:ext cx="6800017" cy="6243848"/>
          </a:xfrm>
          <a:prstGeom prst="rect">
            <a:avLst/>
          </a:prstGeom>
        </p:spPr>
      </p:pic>
      <p:sp>
        <p:nvSpPr>
          <p:cNvPr id="3" name="TextBox 3"/>
          <p:cNvSpPr txBox="1"/>
          <p:nvPr/>
        </p:nvSpPr>
        <p:spPr>
          <a:xfrm>
            <a:off x="731520" y="160020"/>
            <a:ext cx="2009180" cy="1028700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8400"/>
              </a:lnSpc>
            </a:pPr>
            <a:r>
              <a:rPr lang="en-US" sz="60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rPr>
              <a:t>HCPs</a:t>
            </a:r>
          </a:p>
        </p:txBody>
      </p:sp>
      <p:grpSp>
        <p:nvGrpSpPr>
          <p:cNvPr id="4" name="Group 4"/>
          <p:cNvGrpSpPr/>
          <p:nvPr/>
        </p:nvGrpSpPr>
        <p:grpSpPr>
          <a:xfrm>
            <a:off x="6039577" y="976010"/>
            <a:ext cx="3351763" cy="5363181"/>
            <a:chOff x="0" y="0"/>
            <a:chExt cx="4469018" cy="7150908"/>
          </a:xfrm>
        </p:grpSpPr>
        <p:sp>
          <p:nvSpPr>
            <p:cNvPr id="5" name="TextBox 5"/>
            <p:cNvSpPr txBox="1"/>
            <p:nvPr/>
          </p:nvSpPr>
          <p:spPr>
            <a:xfrm>
              <a:off x="490620" y="19050"/>
              <a:ext cx="3939208" cy="6311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Increase digital information effort</a:t>
              </a:r>
            </a:p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 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6" name="Group 6"/>
            <p:cNvGrpSpPr/>
            <p:nvPr/>
          </p:nvGrpSpPr>
          <p:grpSpPr>
            <a:xfrm>
              <a:off x="39190" y="0"/>
              <a:ext cx="159510" cy="259465"/>
              <a:chOff x="0" y="0"/>
              <a:chExt cx="499680" cy="812800"/>
            </a:xfrm>
          </p:grpSpPr>
          <p:sp>
            <p:nvSpPr>
              <p:cNvPr id="7" name="Freeform 7"/>
              <p:cNvSpPr/>
              <p:nvPr/>
            </p:nvSpPr>
            <p:spPr>
              <a:xfrm>
                <a:off x="0" y="0"/>
                <a:ext cx="499680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9680" h="812800">
                    <a:moveTo>
                      <a:pt x="249840" y="0"/>
                    </a:moveTo>
                    <a:lnTo>
                      <a:pt x="249840" y="0"/>
                    </a:lnTo>
                    <a:cubicBezTo>
                      <a:pt x="387823" y="0"/>
                      <a:pt x="499680" y="111857"/>
                      <a:pt x="499680" y="249840"/>
                    </a:cubicBezTo>
                    <a:lnTo>
                      <a:pt x="499680" y="562960"/>
                    </a:lnTo>
                    <a:cubicBezTo>
                      <a:pt x="499680" y="629222"/>
                      <a:pt x="473358" y="692769"/>
                      <a:pt x="426504" y="739624"/>
                    </a:cubicBezTo>
                    <a:cubicBezTo>
                      <a:pt x="379650" y="786478"/>
                      <a:pt x="316102" y="812800"/>
                      <a:pt x="249840" y="812800"/>
                    </a:cubicBezTo>
                    <a:lnTo>
                      <a:pt x="249840" y="812800"/>
                    </a:lnTo>
                    <a:cubicBezTo>
                      <a:pt x="183578" y="812800"/>
                      <a:pt x="120031" y="786478"/>
                      <a:pt x="73176" y="739624"/>
                    </a:cubicBezTo>
                    <a:cubicBezTo>
                      <a:pt x="26322" y="692769"/>
                      <a:pt x="0" y="629222"/>
                      <a:pt x="0" y="562960"/>
                    </a:cubicBezTo>
                    <a:lnTo>
                      <a:pt x="0" y="249840"/>
                    </a:lnTo>
                    <a:cubicBezTo>
                      <a:pt x="0" y="183578"/>
                      <a:pt x="26322" y="120031"/>
                      <a:pt x="73176" y="73176"/>
                    </a:cubicBezTo>
                    <a:cubicBezTo>
                      <a:pt x="120031" y="26322"/>
                      <a:pt x="183578" y="0"/>
                      <a:pt x="249840" y="0"/>
                    </a:cubicBezTo>
                    <a:close/>
                  </a:path>
                </a:pathLst>
              </a:custGeom>
              <a:solidFill>
                <a:srgbClr val="00CADC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8" name="TextBox 8"/>
              <p:cNvSpPr txBox="1"/>
              <p:nvPr/>
            </p:nvSpPr>
            <p:spPr>
              <a:xfrm>
                <a:off x="0" y="-38100"/>
                <a:ext cx="499680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9" name="TextBox 9"/>
            <p:cNvSpPr txBox="1"/>
            <p:nvPr/>
          </p:nvSpPr>
          <p:spPr>
            <a:xfrm>
              <a:off x="513264" y="1234779"/>
              <a:ext cx="3948233" cy="2247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Disease Awareness Campaign </a:t>
              </a:r>
            </a:p>
          </p:txBody>
        </p:sp>
        <p:grpSp>
          <p:nvGrpSpPr>
            <p:cNvPr id="10" name="Group 10"/>
            <p:cNvGrpSpPr/>
            <p:nvPr/>
          </p:nvGrpSpPr>
          <p:grpSpPr>
            <a:xfrm>
              <a:off x="7521" y="1215729"/>
              <a:ext cx="156760" cy="259465"/>
              <a:chOff x="0" y="0"/>
              <a:chExt cx="491065" cy="812800"/>
            </a:xfrm>
          </p:grpSpPr>
          <p:sp>
            <p:nvSpPr>
              <p:cNvPr id="11" name="Freeform 11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49C3FB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2" name="TextBox 12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13" name="TextBox 13"/>
            <p:cNvSpPr txBox="1"/>
            <p:nvPr/>
          </p:nvSpPr>
          <p:spPr>
            <a:xfrm>
              <a:off x="520785" y="2059732"/>
              <a:ext cx="3948233" cy="10375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Institutional activity with co-creation with Association of a needs manifesto based on listening to patients with subsequent institutional table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14" name="Group 14"/>
            <p:cNvGrpSpPr/>
            <p:nvPr/>
          </p:nvGrpSpPr>
          <p:grpSpPr>
            <a:xfrm>
              <a:off x="0" y="2040682"/>
              <a:ext cx="158941" cy="259465"/>
              <a:chOff x="0" y="0"/>
              <a:chExt cx="497899" cy="812800"/>
            </a:xfrm>
          </p:grpSpPr>
          <p:sp>
            <p:nvSpPr>
              <p:cNvPr id="15" name="Freeform 15"/>
              <p:cNvSpPr/>
              <p:nvPr/>
            </p:nvSpPr>
            <p:spPr>
              <a:xfrm>
                <a:off x="0" y="0"/>
                <a:ext cx="497899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7899" h="812800">
                    <a:moveTo>
                      <a:pt x="248950" y="0"/>
                    </a:moveTo>
                    <a:lnTo>
                      <a:pt x="248950" y="0"/>
                    </a:lnTo>
                    <a:cubicBezTo>
                      <a:pt x="386441" y="0"/>
                      <a:pt x="497899" y="111458"/>
                      <a:pt x="497899" y="248950"/>
                    </a:cubicBezTo>
                    <a:lnTo>
                      <a:pt x="497899" y="563851"/>
                    </a:lnTo>
                    <a:cubicBezTo>
                      <a:pt x="497899" y="629876"/>
                      <a:pt x="471670" y="693197"/>
                      <a:pt x="424983" y="739884"/>
                    </a:cubicBezTo>
                    <a:cubicBezTo>
                      <a:pt x="378296" y="786571"/>
                      <a:pt x="314975" y="812800"/>
                      <a:pt x="248950" y="812800"/>
                    </a:cubicBezTo>
                    <a:lnTo>
                      <a:pt x="248950" y="812800"/>
                    </a:lnTo>
                    <a:cubicBezTo>
                      <a:pt x="182924" y="812800"/>
                      <a:pt x="119603" y="786571"/>
                      <a:pt x="72916" y="739884"/>
                    </a:cubicBezTo>
                    <a:cubicBezTo>
                      <a:pt x="26229" y="693197"/>
                      <a:pt x="0" y="629876"/>
                      <a:pt x="0" y="563851"/>
                    </a:cubicBezTo>
                    <a:lnTo>
                      <a:pt x="0" y="248950"/>
                    </a:lnTo>
                    <a:cubicBezTo>
                      <a:pt x="0" y="182924"/>
                      <a:pt x="26229" y="119603"/>
                      <a:pt x="72916" y="72916"/>
                    </a:cubicBezTo>
                    <a:cubicBezTo>
                      <a:pt x="119603" y="26229"/>
                      <a:pt x="182924" y="0"/>
                      <a:pt x="248950" y="0"/>
                    </a:cubicBezTo>
                    <a:close/>
                  </a:path>
                </a:pathLst>
              </a:custGeom>
              <a:solidFill>
                <a:srgbClr val="65A6FA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" name="TextBox 16"/>
              <p:cNvSpPr txBox="1"/>
              <p:nvPr/>
            </p:nvSpPr>
            <p:spPr>
              <a:xfrm>
                <a:off x="0" y="-38100"/>
                <a:ext cx="497899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17" name="TextBox 17"/>
            <p:cNvSpPr txBox="1"/>
            <p:nvPr/>
          </p:nvSpPr>
          <p:spPr>
            <a:xfrm>
              <a:off x="520785" y="3681861"/>
              <a:ext cx="3948233" cy="8343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Cocreation with the patient association of patient materials such as: information pamphlets, patient diary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18" name="Group 18"/>
            <p:cNvGrpSpPr/>
            <p:nvPr/>
          </p:nvGrpSpPr>
          <p:grpSpPr>
            <a:xfrm>
              <a:off x="0" y="3662811"/>
              <a:ext cx="160982" cy="266453"/>
              <a:chOff x="0" y="0"/>
              <a:chExt cx="491065" cy="812800"/>
            </a:xfrm>
          </p:grpSpPr>
          <p:sp>
            <p:nvSpPr>
              <p:cNvPr id="19" name="Freeform 19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7E80E7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20" name="TextBox 20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2168" tIns="52168" rIns="52168" bIns="52168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21" name="TextBox 21"/>
            <p:cNvSpPr txBox="1"/>
            <p:nvPr/>
          </p:nvSpPr>
          <p:spPr>
            <a:xfrm>
              <a:off x="505743" y="5100789"/>
              <a:ext cx="3960267" cy="6311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Information materials to be distributed to GPs 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22" name="Group 22"/>
            <p:cNvGrpSpPr/>
            <p:nvPr/>
          </p:nvGrpSpPr>
          <p:grpSpPr>
            <a:xfrm>
              <a:off x="3008" y="5081739"/>
              <a:ext cx="156760" cy="259465"/>
              <a:chOff x="0" y="0"/>
              <a:chExt cx="491065" cy="812800"/>
            </a:xfrm>
          </p:grpSpPr>
          <p:sp>
            <p:nvSpPr>
              <p:cNvPr id="23" name="Freeform 23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9B57CC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24" name="TextBox 24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25" name="TextBox 25"/>
            <p:cNvSpPr txBox="1"/>
            <p:nvPr/>
          </p:nvSpPr>
          <p:spPr>
            <a:xfrm>
              <a:off x="517776" y="6316518"/>
              <a:ext cx="3948233" cy="8343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Ad Board discussion panels with experienced patients from the association, surgeons, ENT, specialists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26" name="Group 26"/>
            <p:cNvGrpSpPr/>
            <p:nvPr/>
          </p:nvGrpSpPr>
          <p:grpSpPr>
            <a:xfrm>
              <a:off x="3008" y="6297468"/>
              <a:ext cx="156760" cy="259465"/>
              <a:chOff x="0" y="0"/>
              <a:chExt cx="491065" cy="812800"/>
            </a:xfrm>
          </p:grpSpPr>
          <p:sp>
            <p:nvSpPr>
              <p:cNvPr id="27" name="Freeform 27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BB109D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28" name="TextBox 28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2F2F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43378" y="1040562"/>
            <a:ext cx="6693318" cy="6100894"/>
          </a:xfrm>
          <a:prstGeom prst="rect">
            <a:avLst/>
          </a:prstGeom>
        </p:spPr>
      </p:pic>
      <p:sp>
        <p:nvSpPr>
          <p:cNvPr id="3" name="TextBox 3"/>
          <p:cNvSpPr txBox="1"/>
          <p:nvPr/>
        </p:nvSpPr>
        <p:spPr>
          <a:xfrm>
            <a:off x="0" y="-30883"/>
            <a:ext cx="5612035" cy="863599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7000"/>
              </a:lnSpc>
            </a:pPr>
            <a:r>
              <a:rPr lang="en-US" sz="50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rPr>
              <a:t>Patient and PAG</a:t>
            </a:r>
          </a:p>
        </p:txBody>
      </p:sp>
      <p:grpSp>
        <p:nvGrpSpPr>
          <p:cNvPr id="4" name="Group 4"/>
          <p:cNvGrpSpPr/>
          <p:nvPr/>
        </p:nvGrpSpPr>
        <p:grpSpPr>
          <a:xfrm>
            <a:off x="6039577" y="976010"/>
            <a:ext cx="3351763" cy="5363181"/>
            <a:chOff x="0" y="0"/>
            <a:chExt cx="4469018" cy="7150908"/>
          </a:xfrm>
        </p:grpSpPr>
        <p:sp>
          <p:nvSpPr>
            <p:cNvPr id="5" name="TextBox 5"/>
            <p:cNvSpPr txBox="1"/>
            <p:nvPr/>
          </p:nvSpPr>
          <p:spPr>
            <a:xfrm>
              <a:off x="490620" y="19050"/>
              <a:ext cx="3939208" cy="6311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Increase digital information effort</a:t>
              </a:r>
            </a:p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 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6" name="Group 6"/>
            <p:cNvGrpSpPr/>
            <p:nvPr/>
          </p:nvGrpSpPr>
          <p:grpSpPr>
            <a:xfrm>
              <a:off x="39190" y="0"/>
              <a:ext cx="159510" cy="259465"/>
              <a:chOff x="0" y="0"/>
              <a:chExt cx="499680" cy="812800"/>
            </a:xfrm>
          </p:grpSpPr>
          <p:sp>
            <p:nvSpPr>
              <p:cNvPr id="7" name="Freeform 7"/>
              <p:cNvSpPr/>
              <p:nvPr/>
            </p:nvSpPr>
            <p:spPr>
              <a:xfrm>
                <a:off x="0" y="0"/>
                <a:ext cx="499680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9680" h="812800">
                    <a:moveTo>
                      <a:pt x="249840" y="0"/>
                    </a:moveTo>
                    <a:lnTo>
                      <a:pt x="249840" y="0"/>
                    </a:lnTo>
                    <a:cubicBezTo>
                      <a:pt x="387823" y="0"/>
                      <a:pt x="499680" y="111857"/>
                      <a:pt x="499680" y="249840"/>
                    </a:cubicBezTo>
                    <a:lnTo>
                      <a:pt x="499680" y="562960"/>
                    </a:lnTo>
                    <a:cubicBezTo>
                      <a:pt x="499680" y="629222"/>
                      <a:pt x="473358" y="692769"/>
                      <a:pt x="426504" y="739624"/>
                    </a:cubicBezTo>
                    <a:cubicBezTo>
                      <a:pt x="379650" y="786478"/>
                      <a:pt x="316102" y="812800"/>
                      <a:pt x="249840" y="812800"/>
                    </a:cubicBezTo>
                    <a:lnTo>
                      <a:pt x="249840" y="812800"/>
                    </a:lnTo>
                    <a:cubicBezTo>
                      <a:pt x="183578" y="812800"/>
                      <a:pt x="120031" y="786478"/>
                      <a:pt x="73176" y="739624"/>
                    </a:cubicBezTo>
                    <a:cubicBezTo>
                      <a:pt x="26322" y="692769"/>
                      <a:pt x="0" y="629222"/>
                      <a:pt x="0" y="562960"/>
                    </a:cubicBezTo>
                    <a:lnTo>
                      <a:pt x="0" y="249840"/>
                    </a:lnTo>
                    <a:cubicBezTo>
                      <a:pt x="0" y="183578"/>
                      <a:pt x="26322" y="120031"/>
                      <a:pt x="73176" y="73176"/>
                    </a:cubicBezTo>
                    <a:cubicBezTo>
                      <a:pt x="120031" y="26322"/>
                      <a:pt x="183578" y="0"/>
                      <a:pt x="249840" y="0"/>
                    </a:cubicBezTo>
                    <a:close/>
                  </a:path>
                </a:pathLst>
              </a:custGeom>
              <a:solidFill>
                <a:srgbClr val="00CADC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8" name="TextBox 8"/>
              <p:cNvSpPr txBox="1"/>
              <p:nvPr/>
            </p:nvSpPr>
            <p:spPr>
              <a:xfrm>
                <a:off x="0" y="-38100"/>
                <a:ext cx="499680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9" name="TextBox 9"/>
            <p:cNvSpPr txBox="1"/>
            <p:nvPr/>
          </p:nvSpPr>
          <p:spPr>
            <a:xfrm>
              <a:off x="513264" y="1234779"/>
              <a:ext cx="3948233" cy="2247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Disease Awareness Campaign </a:t>
              </a:r>
            </a:p>
          </p:txBody>
        </p:sp>
        <p:grpSp>
          <p:nvGrpSpPr>
            <p:cNvPr id="10" name="Group 10"/>
            <p:cNvGrpSpPr/>
            <p:nvPr/>
          </p:nvGrpSpPr>
          <p:grpSpPr>
            <a:xfrm>
              <a:off x="7521" y="1215729"/>
              <a:ext cx="156760" cy="259465"/>
              <a:chOff x="0" y="0"/>
              <a:chExt cx="491065" cy="812800"/>
            </a:xfrm>
          </p:grpSpPr>
          <p:sp>
            <p:nvSpPr>
              <p:cNvPr id="11" name="Freeform 11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49C3FB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2" name="TextBox 12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13" name="TextBox 13"/>
            <p:cNvSpPr txBox="1"/>
            <p:nvPr/>
          </p:nvSpPr>
          <p:spPr>
            <a:xfrm>
              <a:off x="520785" y="2059732"/>
              <a:ext cx="3948233" cy="10375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 dirty="0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Institutional activity with co-creation with Association of a needs manifesto based on listening to patients with subsequent institutional table</a:t>
              </a:r>
            </a:p>
            <a:p>
              <a:pPr algn="l">
                <a:lnSpc>
                  <a:spcPts val="1200"/>
                </a:lnSpc>
              </a:pPr>
              <a:endParaRPr lang="en-US" sz="1200" b="1" dirty="0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14" name="Group 14"/>
            <p:cNvGrpSpPr/>
            <p:nvPr/>
          </p:nvGrpSpPr>
          <p:grpSpPr>
            <a:xfrm>
              <a:off x="0" y="2040682"/>
              <a:ext cx="158941" cy="259465"/>
              <a:chOff x="0" y="0"/>
              <a:chExt cx="497899" cy="812800"/>
            </a:xfrm>
          </p:grpSpPr>
          <p:sp>
            <p:nvSpPr>
              <p:cNvPr id="15" name="Freeform 15"/>
              <p:cNvSpPr/>
              <p:nvPr/>
            </p:nvSpPr>
            <p:spPr>
              <a:xfrm>
                <a:off x="0" y="0"/>
                <a:ext cx="497899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7899" h="812800">
                    <a:moveTo>
                      <a:pt x="248950" y="0"/>
                    </a:moveTo>
                    <a:lnTo>
                      <a:pt x="248950" y="0"/>
                    </a:lnTo>
                    <a:cubicBezTo>
                      <a:pt x="386441" y="0"/>
                      <a:pt x="497899" y="111458"/>
                      <a:pt x="497899" y="248950"/>
                    </a:cubicBezTo>
                    <a:lnTo>
                      <a:pt x="497899" y="563851"/>
                    </a:lnTo>
                    <a:cubicBezTo>
                      <a:pt x="497899" y="629876"/>
                      <a:pt x="471670" y="693197"/>
                      <a:pt x="424983" y="739884"/>
                    </a:cubicBezTo>
                    <a:cubicBezTo>
                      <a:pt x="378296" y="786571"/>
                      <a:pt x="314975" y="812800"/>
                      <a:pt x="248950" y="812800"/>
                    </a:cubicBezTo>
                    <a:lnTo>
                      <a:pt x="248950" y="812800"/>
                    </a:lnTo>
                    <a:cubicBezTo>
                      <a:pt x="182924" y="812800"/>
                      <a:pt x="119603" y="786571"/>
                      <a:pt x="72916" y="739884"/>
                    </a:cubicBezTo>
                    <a:cubicBezTo>
                      <a:pt x="26229" y="693197"/>
                      <a:pt x="0" y="629876"/>
                      <a:pt x="0" y="563851"/>
                    </a:cubicBezTo>
                    <a:lnTo>
                      <a:pt x="0" y="248950"/>
                    </a:lnTo>
                    <a:cubicBezTo>
                      <a:pt x="0" y="182924"/>
                      <a:pt x="26229" y="119603"/>
                      <a:pt x="72916" y="72916"/>
                    </a:cubicBezTo>
                    <a:cubicBezTo>
                      <a:pt x="119603" y="26229"/>
                      <a:pt x="182924" y="0"/>
                      <a:pt x="248950" y="0"/>
                    </a:cubicBezTo>
                    <a:close/>
                  </a:path>
                </a:pathLst>
              </a:custGeom>
              <a:solidFill>
                <a:srgbClr val="65A6FA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6" name="TextBox 16"/>
              <p:cNvSpPr txBox="1"/>
              <p:nvPr/>
            </p:nvSpPr>
            <p:spPr>
              <a:xfrm>
                <a:off x="0" y="-38100"/>
                <a:ext cx="497899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17" name="TextBox 17"/>
            <p:cNvSpPr txBox="1"/>
            <p:nvPr/>
          </p:nvSpPr>
          <p:spPr>
            <a:xfrm>
              <a:off x="520785" y="3681861"/>
              <a:ext cx="3948233" cy="8343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Cocreation with the patient association of patient materials such as: information pamphlets, patient diary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18" name="Group 18"/>
            <p:cNvGrpSpPr/>
            <p:nvPr/>
          </p:nvGrpSpPr>
          <p:grpSpPr>
            <a:xfrm>
              <a:off x="0" y="3662811"/>
              <a:ext cx="160982" cy="266453"/>
              <a:chOff x="0" y="0"/>
              <a:chExt cx="491065" cy="812800"/>
            </a:xfrm>
          </p:grpSpPr>
          <p:sp>
            <p:nvSpPr>
              <p:cNvPr id="19" name="Freeform 19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7E80E7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20" name="TextBox 20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2168" tIns="52168" rIns="52168" bIns="52168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21" name="TextBox 21"/>
            <p:cNvSpPr txBox="1"/>
            <p:nvPr/>
          </p:nvSpPr>
          <p:spPr>
            <a:xfrm>
              <a:off x="505743" y="5100789"/>
              <a:ext cx="3960267" cy="6311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Information materials to be distributed to GPs 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22" name="Group 22"/>
            <p:cNvGrpSpPr/>
            <p:nvPr/>
          </p:nvGrpSpPr>
          <p:grpSpPr>
            <a:xfrm>
              <a:off x="3008" y="5081739"/>
              <a:ext cx="156760" cy="259465"/>
              <a:chOff x="0" y="0"/>
              <a:chExt cx="491065" cy="812800"/>
            </a:xfrm>
          </p:grpSpPr>
          <p:sp>
            <p:nvSpPr>
              <p:cNvPr id="23" name="Freeform 23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9B57CC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24" name="TextBox 24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  <p:sp>
          <p:nvSpPr>
            <p:cNvPr id="25" name="TextBox 25"/>
            <p:cNvSpPr txBox="1"/>
            <p:nvPr/>
          </p:nvSpPr>
          <p:spPr>
            <a:xfrm>
              <a:off x="517776" y="6316518"/>
              <a:ext cx="3948233" cy="83439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200"/>
                </a:lnSpc>
              </a:pPr>
              <a:r>
                <a:rPr lang="en-US" sz="1200" b="1">
                  <a:solidFill>
                    <a:srgbClr val="666666"/>
                  </a:solidFill>
                  <a:latin typeface="Canva Sans 1 Bold"/>
                  <a:ea typeface="Canva Sans 1 Bold"/>
                  <a:cs typeface="Canva Sans 1 Bold"/>
                  <a:sym typeface="Canva Sans 1 Bold"/>
                </a:rPr>
                <a:t>Ad Board discussion panels with experienced patients from the association, surgeons, ENT, specialists</a:t>
              </a:r>
            </a:p>
            <a:p>
              <a:pPr algn="l">
                <a:lnSpc>
                  <a:spcPts val="1200"/>
                </a:lnSpc>
              </a:pPr>
              <a:endParaRPr lang="en-US" sz="1200" b="1">
                <a:solidFill>
                  <a:srgbClr val="666666"/>
                </a:solidFill>
                <a:latin typeface="Canva Sans 1 Bold"/>
                <a:ea typeface="Canva Sans 1 Bold"/>
                <a:cs typeface="Canva Sans 1 Bold"/>
                <a:sym typeface="Canva Sans 1 Bold"/>
              </a:endParaRPr>
            </a:p>
          </p:txBody>
        </p:sp>
        <p:grpSp>
          <p:nvGrpSpPr>
            <p:cNvPr id="26" name="Group 26"/>
            <p:cNvGrpSpPr/>
            <p:nvPr/>
          </p:nvGrpSpPr>
          <p:grpSpPr>
            <a:xfrm>
              <a:off x="3008" y="6297468"/>
              <a:ext cx="156760" cy="259465"/>
              <a:chOff x="0" y="0"/>
              <a:chExt cx="491065" cy="812800"/>
            </a:xfrm>
          </p:grpSpPr>
          <p:sp>
            <p:nvSpPr>
              <p:cNvPr id="27" name="Freeform 27"/>
              <p:cNvSpPr/>
              <p:nvPr/>
            </p:nvSpPr>
            <p:spPr>
              <a:xfrm>
                <a:off x="0" y="0"/>
                <a:ext cx="491065" cy="812800"/>
              </a:xfrm>
              <a:custGeom>
                <a:avLst/>
                <a:gdLst/>
                <a:ahLst/>
                <a:cxnLst/>
                <a:rect l="l" t="t" r="r" b="b"/>
                <a:pathLst>
                  <a:path w="491065" h="812800">
                    <a:moveTo>
                      <a:pt x="245533" y="0"/>
                    </a:moveTo>
                    <a:lnTo>
                      <a:pt x="245533" y="0"/>
                    </a:lnTo>
                    <a:cubicBezTo>
                      <a:pt x="381137" y="0"/>
                      <a:pt x="491065" y="109929"/>
                      <a:pt x="491065" y="245533"/>
                    </a:cubicBezTo>
                    <a:lnTo>
                      <a:pt x="491065" y="567267"/>
                    </a:lnTo>
                    <a:cubicBezTo>
                      <a:pt x="491065" y="702871"/>
                      <a:pt x="381137" y="812800"/>
                      <a:pt x="245533" y="812800"/>
                    </a:cubicBezTo>
                    <a:lnTo>
                      <a:pt x="245533" y="812800"/>
                    </a:lnTo>
                    <a:cubicBezTo>
                      <a:pt x="109929" y="812800"/>
                      <a:pt x="0" y="702871"/>
                      <a:pt x="0" y="567267"/>
                    </a:cubicBezTo>
                    <a:lnTo>
                      <a:pt x="0" y="245533"/>
                    </a:lnTo>
                    <a:cubicBezTo>
                      <a:pt x="0" y="109929"/>
                      <a:pt x="109929" y="0"/>
                      <a:pt x="245533" y="0"/>
                    </a:cubicBezTo>
                    <a:close/>
                  </a:path>
                </a:pathLst>
              </a:custGeom>
              <a:solidFill>
                <a:srgbClr val="BB109D"/>
              </a:solidFill>
              <a:ln cap="sq">
                <a:noFill/>
                <a:prstDash val="solid"/>
                <a:miter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28" name="TextBox 28"/>
              <p:cNvSpPr txBox="1"/>
              <p:nvPr/>
            </p:nvSpPr>
            <p:spPr>
              <a:xfrm>
                <a:off x="0" y="-38100"/>
                <a:ext cx="491065" cy="850900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pPr algn="ctr">
                  <a:lnSpc>
                    <a:spcPts val="1680"/>
                  </a:lnSpc>
                  <a:spcBef>
                    <a:spcPct val="0"/>
                  </a:spcBef>
                </a:pPr>
                <a:endParaRPr/>
              </a:p>
            </p:txBody>
          </p:sp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02032B8B-8844-DE6E-EAC3-FB4566DC59C5}"/>
              </a:ext>
            </a:extLst>
          </p:cNvPr>
          <p:cNvGrpSpPr/>
          <p:nvPr/>
        </p:nvGrpSpPr>
        <p:grpSpPr>
          <a:xfrm>
            <a:off x="1747520" y="203835"/>
            <a:ext cx="6258560" cy="6907530"/>
            <a:chOff x="0" y="0"/>
            <a:chExt cx="9461202" cy="5859027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2D0A7E7D-4FD2-4A1A-EF18-DF3FB729358E}"/>
                </a:ext>
              </a:extLst>
            </p:cNvPr>
            <p:cNvGrpSpPr/>
            <p:nvPr/>
          </p:nvGrpSpPr>
          <p:grpSpPr>
            <a:xfrm>
              <a:off x="4795841" y="480920"/>
              <a:ext cx="4665361" cy="5354941"/>
              <a:chOff x="4795841" y="480920"/>
              <a:chExt cx="1764157" cy="2201705"/>
            </a:xfrm>
          </p:grpSpPr>
          <p:sp>
            <p:nvSpPr>
              <p:cNvPr id="83" name="Freeform 12">
                <a:extLst>
                  <a:ext uri="{FF2B5EF4-FFF2-40B4-BE49-F238E27FC236}">
                    <a16:creationId xmlns:a16="http://schemas.microsoft.com/office/drawing/2014/main" id="{7221144F-710C-6D0E-807B-9B5D8A6281DE}"/>
                  </a:ext>
                </a:extLst>
              </p:cNvPr>
              <p:cNvSpPr/>
              <p:nvPr/>
            </p:nvSpPr>
            <p:spPr>
              <a:xfrm>
                <a:off x="4795841" y="490445"/>
                <a:ext cx="1764157" cy="2192180"/>
              </a:xfrm>
              <a:custGeom>
                <a:avLst/>
                <a:gdLst/>
                <a:ahLst/>
                <a:cxnLst/>
                <a:rect l="l" t="t" r="r" b="b"/>
                <a:pathLst>
                  <a:path w="1764157" h="2192180">
                    <a:moveTo>
                      <a:pt x="24892" y="0"/>
                    </a:moveTo>
                    <a:lnTo>
                      <a:pt x="1739265" y="0"/>
                    </a:lnTo>
                    <a:cubicBezTo>
                      <a:pt x="1753013" y="0"/>
                      <a:pt x="1764157" y="11144"/>
                      <a:pt x="1764157" y="24892"/>
                    </a:cubicBezTo>
                    <a:lnTo>
                      <a:pt x="1764157" y="2167288"/>
                    </a:lnTo>
                    <a:cubicBezTo>
                      <a:pt x="1764157" y="2181035"/>
                      <a:pt x="1753013" y="2192180"/>
                      <a:pt x="1739265" y="2192180"/>
                    </a:cubicBezTo>
                    <a:lnTo>
                      <a:pt x="24892" y="2192180"/>
                    </a:lnTo>
                    <a:cubicBezTo>
                      <a:pt x="11144" y="2192180"/>
                      <a:pt x="0" y="2181035"/>
                      <a:pt x="0" y="2167288"/>
                    </a:cubicBezTo>
                    <a:lnTo>
                      <a:pt x="0" y="24892"/>
                    </a:lnTo>
                    <a:cubicBezTo>
                      <a:pt x="0" y="11144"/>
                      <a:pt x="11144" y="0"/>
                      <a:pt x="24892" y="0"/>
                    </a:cubicBezTo>
                    <a:close/>
                  </a:path>
                </a:pathLst>
              </a:custGeom>
              <a:solidFill>
                <a:srgbClr val="41B8D5"/>
              </a:solidFill>
              <a:ln cap="sq">
                <a:noFill/>
                <a:prstDash val="solid"/>
                <a:miter lim="0"/>
              </a:ln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84" name="TextBox 13">
                <a:extLst>
                  <a:ext uri="{FF2B5EF4-FFF2-40B4-BE49-F238E27FC236}">
                    <a16:creationId xmlns:a16="http://schemas.microsoft.com/office/drawing/2014/main" id="{9313B28A-1E1E-0115-C5CF-4C029C8A6F35}"/>
                  </a:ext>
                </a:extLst>
              </p:cNvPr>
              <p:cNvSpPr txBox="1"/>
              <p:nvPr/>
            </p:nvSpPr>
            <p:spPr>
              <a:xfrm>
                <a:off x="4795841" y="480920"/>
                <a:ext cx="1764157" cy="2201705"/>
              </a:xfrm>
              <a:prstGeom prst="rect">
                <a:avLst/>
              </a:prstGeom>
            </p:spPr>
            <p:txBody>
              <a:bodyPr lIns="50800" tIns="50800" rIns="50800" bIns="50800" rtlCol="0" anchor="ctr"/>
              <a:lstStyle/>
              <a:p>
                <a:endParaRPr lang="it-IT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9AD1311A-F1E2-5EBC-D29B-FBB260E21AAC}"/>
                </a:ext>
              </a:extLst>
            </p:cNvPr>
            <p:cNvGrpSpPr/>
            <p:nvPr/>
          </p:nvGrpSpPr>
          <p:grpSpPr>
            <a:xfrm>
              <a:off x="0" y="0"/>
              <a:ext cx="9330878" cy="5859027"/>
              <a:chOff x="0" y="0"/>
              <a:chExt cx="9330878" cy="5859027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4FE9BBB7-C594-23D2-9567-7DD16A902258}"/>
                  </a:ext>
                </a:extLst>
              </p:cNvPr>
              <p:cNvGrpSpPr/>
              <p:nvPr/>
            </p:nvGrpSpPr>
            <p:grpSpPr>
              <a:xfrm>
                <a:off x="0" y="480819"/>
                <a:ext cx="4665361" cy="5378208"/>
                <a:chOff x="0" y="480819"/>
                <a:chExt cx="1764157" cy="2201705"/>
              </a:xfrm>
            </p:grpSpPr>
            <p:sp>
              <p:nvSpPr>
                <p:cNvPr id="81" name="Freeform 9">
                  <a:extLst>
                    <a:ext uri="{FF2B5EF4-FFF2-40B4-BE49-F238E27FC236}">
                      <a16:creationId xmlns:a16="http://schemas.microsoft.com/office/drawing/2014/main" id="{368867AC-AC36-D287-A7A9-089D688B2FCD}"/>
                    </a:ext>
                  </a:extLst>
                </p:cNvPr>
                <p:cNvSpPr/>
                <p:nvPr/>
              </p:nvSpPr>
              <p:spPr>
                <a:xfrm>
                  <a:off x="0" y="490344"/>
                  <a:ext cx="1764157" cy="219218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764157" h="2192180">
                      <a:moveTo>
                        <a:pt x="24892" y="0"/>
                      </a:moveTo>
                      <a:lnTo>
                        <a:pt x="1739265" y="0"/>
                      </a:lnTo>
                      <a:cubicBezTo>
                        <a:pt x="1753013" y="0"/>
                        <a:pt x="1764157" y="11144"/>
                        <a:pt x="1764157" y="24892"/>
                      </a:cubicBezTo>
                      <a:lnTo>
                        <a:pt x="1764157" y="2167288"/>
                      </a:lnTo>
                      <a:cubicBezTo>
                        <a:pt x="1764157" y="2181035"/>
                        <a:pt x="1753013" y="2192180"/>
                        <a:pt x="1739265" y="2192180"/>
                      </a:cubicBezTo>
                      <a:lnTo>
                        <a:pt x="24892" y="2192180"/>
                      </a:lnTo>
                      <a:cubicBezTo>
                        <a:pt x="11144" y="2192180"/>
                        <a:pt x="0" y="2181035"/>
                        <a:pt x="0" y="2167288"/>
                      </a:cubicBezTo>
                      <a:lnTo>
                        <a:pt x="0" y="24892"/>
                      </a:lnTo>
                      <a:cubicBezTo>
                        <a:pt x="0" y="11144"/>
                        <a:pt x="11144" y="0"/>
                        <a:pt x="24892" y="0"/>
                      </a:cubicBezTo>
                      <a:close/>
                    </a:path>
                  </a:pathLst>
                </a:custGeom>
                <a:solidFill>
                  <a:srgbClr val="41B8D5"/>
                </a:solidFill>
                <a:ln cap="sq">
                  <a:noFill/>
                  <a:prstDash val="solid"/>
                  <a:miter lim="0"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82" name="TextBox 10">
                  <a:extLst>
                    <a:ext uri="{FF2B5EF4-FFF2-40B4-BE49-F238E27FC236}">
                      <a16:creationId xmlns:a16="http://schemas.microsoft.com/office/drawing/2014/main" id="{B9EC460F-857F-7430-2215-186868A46CEC}"/>
                    </a:ext>
                  </a:extLst>
                </p:cNvPr>
                <p:cNvSpPr txBox="1"/>
                <p:nvPr/>
              </p:nvSpPr>
              <p:spPr>
                <a:xfrm>
                  <a:off x="0" y="480819"/>
                  <a:ext cx="1764157" cy="2201705"/>
                </a:xfrm>
                <a:prstGeom prst="rect">
                  <a:avLst/>
                </a:prstGeom>
              </p:spPr>
              <p:txBody>
                <a:bodyPr lIns="50800" tIns="50800" rIns="50800" bIns="50800" rtlCol="0" anchor="ctr"/>
                <a:lstStyle/>
                <a:p>
                  <a:endParaRPr lang="it-IT"/>
                </a:p>
              </p:txBody>
            </p:sp>
          </p:grp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C9D6AFD4-78ED-3E0D-161C-608FC56D6842}"/>
                  </a:ext>
                </a:extLst>
              </p:cNvPr>
              <p:cNvGrpSpPr/>
              <p:nvPr/>
            </p:nvGrpSpPr>
            <p:grpSpPr>
              <a:xfrm>
                <a:off x="70677" y="0"/>
                <a:ext cx="9260201" cy="5822082"/>
                <a:chOff x="70677" y="0"/>
                <a:chExt cx="9260201" cy="5822082"/>
              </a:xfrm>
            </p:grpSpPr>
            <p:grpSp>
              <p:nvGrpSpPr>
                <p:cNvPr id="34" name="Group 33">
                  <a:extLst>
                    <a:ext uri="{FF2B5EF4-FFF2-40B4-BE49-F238E27FC236}">
                      <a16:creationId xmlns:a16="http://schemas.microsoft.com/office/drawing/2014/main" id="{900381B3-2DFE-4A65-C3B2-09DC15FF34FA}"/>
                    </a:ext>
                  </a:extLst>
                </p:cNvPr>
                <p:cNvGrpSpPr/>
                <p:nvPr/>
              </p:nvGrpSpPr>
              <p:grpSpPr>
                <a:xfrm>
                  <a:off x="320449" y="0"/>
                  <a:ext cx="4024462" cy="5822082"/>
                  <a:chOff x="320449" y="0"/>
                  <a:chExt cx="1989600" cy="3061022"/>
                </a:xfrm>
              </p:grpSpPr>
              <p:sp>
                <p:nvSpPr>
                  <p:cNvPr id="79" name="Freeform 3">
                    <a:extLst>
                      <a:ext uri="{FF2B5EF4-FFF2-40B4-BE49-F238E27FC236}">
                        <a16:creationId xmlns:a16="http://schemas.microsoft.com/office/drawing/2014/main" id="{D948B3EB-87D1-0AD9-302A-A1EFE929D0B4}"/>
                      </a:ext>
                    </a:extLst>
                  </p:cNvPr>
                  <p:cNvSpPr/>
                  <p:nvPr/>
                </p:nvSpPr>
                <p:spPr>
                  <a:xfrm>
                    <a:off x="320449" y="9525"/>
                    <a:ext cx="1989599" cy="305149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1989599" h="3051497">
                        <a:moveTo>
                          <a:pt x="38474" y="0"/>
                        </a:moveTo>
                        <a:lnTo>
                          <a:pt x="1951125" y="0"/>
                        </a:lnTo>
                        <a:cubicBezTo>
                          <a:pt x="1972374" y="0"/>
                          <a:pt x="1989599" y="17226"/>
                          <a:pt x="1989599" y="38474"/>
                        </a:cubicBezTo>
                        <a:lnTo>
                          <a:pt x="1989599" y="3013022"/>
                        </a:lnTo>
                        <a:cubicBezTo>
                          <a:pt x="1989599" y="3023226"/>
                          <a:pt x="1985546" y="3033013"/>
                          <a:pt x="1978331" y="3040228"/>
                        </a:cubicBezTo>
                        <a:cubicBezTo>
                          <a:pt x="1971115" y="3047443"/>
                          <a:pt x="1961329" y="3051497"/>
                          <a:pt x="1951125" y="3051497"/>
                        </a:cubicBezTo>
                        <a:lnTo>
                          <a:pt x="38474" y="3051497"/>
                        </a:lnTo>
                        <a:cubicBezTo>
                          <a:pt x="28270" y="3051497"/>
                          <a:pt x="18484" y="3047443"/>
                          <a:pt x="11269" y="3040228"/>
                        </a:cubicBezTo>
                        <a:cubicBezTo>
                          <a:pt x="4054" y="3033013"/>
                          <a:pt x="0" y="3023226"/>
                          <a:pt x="0" y="3013022"/>
                        </a:cubicBezTo>
                        <a:lnTo>
                          <a:pt x="0" y="38474"/>
                        </a:lnTo>
                        <a:cubicBezTo>
                          <a:pt x="0" y="28270"/>
                          <a:pt x="4054" y="18484"/>
                          <a:pt x="11269" y="11269"/>
                        </a:cubicBezTo>
                        <a:cubicBezTo>
                          <a:pt x="18484" y="4054"/>
                          <a:pt x="28270" y="0"/>
                          <a:pt x="38474" y="0"/>
                        </a:cubicBezTo>
                        <a:close/>
                      </a:path>
                    </a:pathLst>
                  </a:custGeom>
                  <a:solidFill>
                    <a:srgbClr val="41B8D5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80" name="TextBox 4">
                    <a:extLst>
                      <a:ext uri="{FF2B5EF4-FFF2-40B4-BE49-F238E27FC236}">
                        <a16:creationId xmlns:a16="http://schemas.microsoft.com/office/drawing/2014/main" id="{81649C7F-F04F-4A3F-86B1-325BEF9AA66F}"/>
                      </a:ext>
                    </a:extLst>
                  </p:cNvPr>
                  <p:cNvSpPr txBox="1"/>
                  <p:nvPr/>
                </p:nvSpPr>
                <p:spPr>
                  <a:xfrm>
                    <a:off x="320449" y="0"/>
                    <a:ext cx="1989600" cy="3061022"/>
                  </a:xfrm>
                  <a:prstGeom prst="rect">
                    <a:avLst/>
                  </a:prstGeom>
                </p:spPr>
                <p:txBody>
                  <a:bodyPr lIns="50800" tIns="50800" rIns="50800" bIns="50800" rtlCol="0" anchor="ctr"/>
                  <a:lstStyle/>
                  <a:p>
                    <a:endParaRPr lang="it-IT"/>
                  </a:p>
                </p:txBody>
              </p:sp>
            </p:grpSp>
            <p:grpSp>
              <p:nvGrpSpPr>
                <p:cNvPr id="35" name="Group 34">
                  <a:extLst>
                    <a:ext uri="{FF2B5EF4-FFF2-40B4-BE49-F238E27FC236}">
                      <a16:creationId xmlns:a16="http://schemas.microsoft.com/office/drawing/2014/main" id="{60F8171D-700B-B2E9-BACC-C535888AA72A}"/>
                    </a:ext>
                  </a:extLst>
                </p:cNvPr>
                <p:cNvGrpSpPr/>
                <p:nvPr/>
              </p:nvGrpSpPr>
              <p:grpSpPr>
                <a:xfrm>
                  <a:off x="5116291" y="73"/>
                  <a:ext cx="4024462" cy="5798842"/>
                  <a:chOff x="5116291" y="73"/>
                  <a:chExt cx="1989600" cy="3061022"/>
                </a:xfrm>
              </p:grpSpPr>
              <p:sp>
                <p:nvSpPr>
                  <p:cNvPr id="77" name="Freeform 6">
                    <a:extLst>
                      <a:ext uri="{FF2B5EF4-FFF2-40B4-BE49-F238E27FC236}">
                        <a16:creationId xmlns:a16="http://schemas.microsoft.com/office/drawing/2014/main" id="{C8F82231-239C-50ED-1D54-C98038CD240E}"/>
                      </a:ext>
                    </a:extLst>
                  </p:cNvPr>
                  <p:cNvSpPr/>
                  <p:nvPr/>
                </p:nvSpPr>
                <p:spPr>
                  <a:xfrm>
                    <a:off x="5116291" y="9598"/>
                    <a:ext cx="1989599" cy="305149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1989599" h="3051497">
                        <a:moveTo>
                          <a:pt x="38474" y="0"/>
                        </a:moveTo>
                        <a:lnTo>
                          <a:pt x="1951125" y="0"/>
                        </a:lnTo>
                        <a:cubicBezTo>
                          <a:pt x="1972374" y="0"/>
                          <a:pt x="1989599" y="17226"/>
                          <a:pt x="1989599" y="38474"/>
                        </a:cubicBezTo>
                        <a:lnTo>
                          <a:pt x="1989599" y="3013022"/>
                        </a:lnTo>
                        <a:cubicBezTo>
                          <a:pt x="1989599" y="3023226"/>
                          <a:pt x="1985546" y="3033013"/>
                          <a:pt x="1978331" y="3040228"/>
                        </a:cubicBezTo>
                        <a:cubicBezTo>
                          <a:pt x="1971115" y="3047443"/>
                          <a:pt x="1961329" y="3051497"/>
                          <a:pt x="1951125" y="3051497"/>
                        </a:cubicBezTo>
                        <a:lnTo>
                          <a:pt x="38474" y="3051497"/>
                        </a:lnTo>
                        <a:cubicBezTo>
                          <a:pt x="28270" y="3051497"/>
                          <a:pt x="18484" y="3047443"/>
                          <a:pt x="11269" y="3040228"/>
                        </a:cubicBezTo>
                        <a:cubicBezTo>
                          <a:pt x="4054" y="3033013"/>
                          <a:pt x="0" y="3023226"/>
                          <a:pt x="0" y="3013022"/>
                        </a:cubicBezTo>
                        <a:lnTo>
                          <a:pt x="0" y="38474"/>
                        </a:lnTo>
                        <a:cubicBezTo>
                          <a:pt x="0" y="28270"/>
                          <a:pt x="4054" y="18484"/>
                          <a:pt x="11269" y="11269"/>
                        </a:cubicBezTo>
                        <a:cubicBezTo>
                          <a:pt x="18484" y="4054"/>
                          <a:pt x="28270" y="0"/>
                          <a:pt x="38474" y="0"/>
                        </a:cubicBezTo>
                        <a:close/>
                      </a:path>
                    </a:pathLst>
                  </a:custGeom>
                  <a:solidFill>
                    <a:srgbClr val="41B8D5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78" name="TextBox 7">
                    <a:extLst>
                      <a:ext uri="{FF2B5EF4-FFF2-40B4-BE49-F238E27FC236}">
                        <a16:creationId xmlns:a16="http://schemas.microsoft.com/office/drawing/2014/main" id="{46C4B25E-4BD2-3A66-5EF9-DE95327B5F3A}"/>
                      </a:ext>
                    </a:extLst>
                  </p:cNvPr>
                  <p:cNvSpPr txBox="1"/>
                  <p:nvPr/>
                </p:nvSpPr>
                <p:spPr>
                  <a:xfrm>
                    <a:off x="5116291" y="73"/>
                    <a:ext cx="1989600" cy="3061022"/>
                  </a:xfrm>
                  <a:prstGeom prst="rect">
                    <a:avLst/>
                  </a:prstGeom>
                </p:spPr>
                <p:txBody>
                  <a:bodyPr lIns="50800" tIns="50800" rIns="50800" bIns="50800" rtlCol="0" anchor="ctr"/>
                  <a:lstStyle/>
                  <a:p>
                    <a:endParaRPr lang="it-IT"/>
                  </a:p>
                </p:txBody>
              </p:sp>
            </p:grpSp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4211D904-5EAE-D4FB-51C1-97A45D5ACDF3}"/>
                    </a:ext>
                  </a:extLst>
                </p:cNvPr>
                <p:cNvGrpSpPr/>
                <p:nvPr/>
              </p:nvGrpSpPr>
              <p:grpSpPr>
                <a:xfrm>
                  <a:off x="130324" y="555453"/>
                  <a:ext cx="4404713" cy="674998"/>
                  <a:chOff x="130324" y="555453"/>
                  <a:chExt cx="737655" cy="113042"/>
                </a:xfrm>
              </p:grpSpPr>
              <p:sp>
                <p:nvSpPr>
                  <p:cNvPr id="75" name="Freeform 15">
                    <a:extLst>
                      <a:ext uri="{FF2B5EF4-FFF2-40B4-BE49-F238E27FC236}">
                        <a16:creationId xmlns:a16="http://schemas.microsoft.com/office/drawing/2014/main" id="{576E0118-A7F8-D2C5-92FD-A831B870BA64}"/>
                      </a:ext>
                    </a:extLst>
                  </p:cNvPr>
                  <p:cNvSpPr/>
                  <p:nvPr/>
                </p:nvSpPr>
                <p:spPr>
                  <a:xfrm>
                    <a:off x="130324" y="563136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A1E1FD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76" name="TextBox 16">
                    <a:extLst>
                      <a:ext uri="{FF2B5EF4-FFF2-40B4-BE49-F238E27FC236}">
                        <a16:creationId xmlns:a16="http://schemas.microsoft.com/office/drawing/2014/main" id="{513C1E2C-4D6A-09D3-1E44-480CBD027D84}"/>
                      </a:ext>
                    </a:extLst>
                  </p:cNvPr>
                  <p:cNvSpPr txBox="1"/>
                  <p:nvPr/>
                </p:nvSpPr>
                <p:spPr>
                  <a:xfrm>
                    <a:off x="130324" y="555453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 dirty="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Lack of </a:t>
                    </a:r>
                    <a:r>
                      <a:rPr lang="en-GB" sz="900" b="1" kern="1200" dirty="0">
                        <a:solidFill>
                          <a:srgbClr val="048BC8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oordination between care providers</a:t>
                    </a:r>
                    <a:endParaRPr lang="it-IT" sz="1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4C0B0141-8028-C6C0-FF08-F0F919DDB046}"/>
                    </a:ext>
                  </a:extLst>
                </p:cNvPr>
                <p:cNvGrpSpPr/>
                <p:nvPr/>
              </p:nvGrpSpPr>
              <p:grpSpPr>
                <a:xfrm>
                  <a:off x="4926165" y="483618"/>
                  <a:ext cx="4404713" cy="1464351"/>
                  <a:chOff x="4926165" y="483618"/>
                  <a:chExt cx="737655" cy="245234"/>
                </a:xfrm>
              </p:grpSpPr>
              <p:sp>
                <p:nvSpPr>
                  <p:cNvPr id="73" name="Freeform 18">
                    <a:extLst>
                      <a:ext uri="{FF2B5EF4-FFF2-40B4-BE49-F238E27FC236}">
                        <a16:creationId xmlns:a16="http://schemas.microsoft.com/office/drawing/2014/main" id="{56B7BE20-7012-C48A-AA67-AAFC9022F3A6}"/>
                      </a:ext>
                    </a:extLst>
                  </p:cNvPr>
                  <p:cNvSpPr/>
                  <p:nvPr/>
                </p:nvSpPr>
                <p:spPr>
                  <a:xfrm>
                    <a:off x="4926165" y="503333"/>
                    <a:ext cx="737655" cy="225519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225519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207943"/>
                        </a:lnTo>
                        <a:cubicBezTo>
                          <a:pt x="737655" y="212605"/>
                          <a:pt x="735803" y="217075"/>
                          <a:pt x="732507" y="220371"/>
                        </a:cubicBezTo>
                        <a:cubicBezTo>
                          <a:pt x="729211" y="223668"/>
                          <a:pt x="724740" y="225519"/>
                          <a:pt x="720078" y="225519"/>
                        </a:cubicBezTo>
                        <a:lnTo>
                          <a:pt x="17576" y="225519"/>
                        </a:lnTo>
                        <a:cubicBezTo>
                          <a:pt x="12915" y="225519"/>
                          <a:pt x="8444" y="223668"/>
                          <a:pt x="5148" y="220371"/>
                        </a:cubicBezTo>
                        <a:cubicBezTo>
                          <a:pt x="1852" y="217075"/>
                          <a:pt x="0" y="212605"/>
                          <a:pt x="0" y="207943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A1E1FD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74" name="TextBox 19">
                    <a:extLst>
                      <a:ext uri="{FF2B5EF4-FFF2-40B4-BE49-F238E27FC236}">
                        <a16:creationId xmlns:a16="http://schemas.microsoft.com/office/drawing/2014/main" id="{302AD62E-D4AA-A1FA-6CEB-726769173BCB}"/>
                      </a:ext>
                    </a:extLst>
                  </p:cNvPr>
                  <p:cNvSpPr txBox="1"/>
                  <p:nvPr/>
                </p:nvSpPr>
                <p:spPr>
                  <a:xfrm>
                    <a:off x="4926165" y="483618"/>
                    <a:ext cx="737655" cy="235044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Patient not assessed by </a:t>
                    </a:r>
                    <a:r>
                      <a:rPr lang="en-GB" sz="900" b="1" kern="1200">
                        <a:solidFill>
                          <a:srgbClr val="048BC8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multidisciplinary team</a:t>
                    </a: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/</a:t>
                    </a:r>
                    <a:r>
                      <a:rPr lang="en-GB" sz="900" b="1" kern="1200">
                        <a:solidFill>
                          <a:srgbClr val="4E51DE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comorbidities</a:t>
                    </a: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not always considered (asthma, allergy, etc.)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A9BA5B49-C08C-AF2A-22D4-D3A4D0CF2CD4}"/>
                    </a:ext>
                  </a:extLst>
                </p:cNvPr>
                <p:cNvGrpSpPr/>
                <p:nvPr/>
              </p:nvGrpSpPr>
              <p:grpSpPr>
                <a:xfrm>
                  <a:off x="4855486" y="1999512"/>
                  <a:ext cx="4475388" cy="895330"/>
                  <a:chOff x="4855486" y="1999512"/>
                  <a:chExt cx="749491" cy="149941"/>
                </a:xfrm>
              </p:grpSpPr>
              <p:sp>
                <p:nvSpPr>
                  <p:cNvPr id="71" name="Freeform 21">
                    <a:extLst>
                      <a:ext uri="{FF2B5EF4-FFF2-40B4-BE49-F238E27FC236}">
                        <a16:creationId xmlns:a16="http://schemas.microsoft.com/office/drawing/2014/main" id="{A55F3A04-FB3B-C7C8-A769-8F28DE509894}"/>
                      </a:ext>
                    </a:extLst>
                  </p:cNvPr>
                  <p:cNvSpPr/>
                  <p:nvPr/>
                </p:nvSpPr>
                <p:spPr>
                  <a:xfrm>
                    <a:off x="4867322" y="2002250"/>
                    <a:ext cx="737655" cy="140416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40416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122839"/>
                        </a:lnTo>
                        <a:cubicBezTo>
                          <a:pt x="737655" y="127501"/>
                          <a:pt x="735803" y="131971"/>
                          <a:pt x="732507" y="135268"/>
                        </a:cubicBezTo>
                        <a:cubicBezTo>
                          <a:pt x="729211" y="138564"/>
                          <a:pt x="724740" y="140416"/>
                          <a:pt x="720078" y="140416"/>
                        </a:cubicBezTo>
                        <a:lnTo>
                          <a:pt x="17576" y="140416"/>
                        </a:lnTo>
                        <a:cubicBezTo>
                          <a:pt x="12915" y="140416"/>
                          <a:pt x="8444" y="138564"/>
                          <a:pt x="5148" y="135268"/>
                        </a:cubicBezTo>
                        <a:cubicBezTo>
                          <a:pt x="1852" y="131971"/>
                          <a:pt x="0" y="127501"/>
                          <a:pt x="0" y="122839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85B8FB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72" name="TextBox 22">
                    <a:extLst>
                      <a:ext uri="{FF2B5EF4-FFF2-40B4-BE49-F238E27FC236}">
                        <a16:creationId xmlns:a16="http://schemas.microsoft.com/office/drawing/2014/main" id="{2FD88568-3C26-6FAB-EEF9-1485CBBC80F2}"/>
                      </a:ext>
                    </a:extLst>
                  </p:cNvPr>
                  <p:cNvSpPr txBox="1"/>
                  <p:nvPr/>
                </p:nvSpPr>
                <p:spPr>
                  <a:xfrm>
                    <a:off x="4855486" y="1999512"/>
                    <a:ext cx="737655" cy="149941"/>
                  </a:xfrm>
                  <a:prstGeom prst="rect">
                    <a:avLst/>
                  </a:prstGeom>
                  <a:noFill/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7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Lack of healthcare system diagnostic-therapeutic journey to support management, with consequent inequalities between different Regions and enormous costs for testing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AB26FAE7-E9D3-7C72-F85B-AD6EEBF51672}"/>
                    </a:ext>
                  </a:extLst>
                </p:cNvPr>
                <p:cNvGrpSpPr/>
                <p:nvPr/>
              </p:nvGrpSpPr>
              <p:grpSpPr>
                <a:xfrm>
                  <a:off x="4926165" y="2939095"/>
                  <a:ext cx="4404713" cy="675001"/>
                  <a:chOff x="4926165" y="2939095"/>
                  <a:chExt cx="737655" cy="113042"/>
                </a:xfrm>
              </p:grpSpPr>
              <p:sp>
                <p:nvSpPr>
                  <p:cNvPr id="69" name="Freeform 24">
                    <a:extLst>
                      <a:ext uri="{FF2B5EF4-FFF2-40B4-BE49-F238E27FC236}">
                        <a16:creationId xmlns:a16="http://schemas.microsoft.com/office/drawing/2014/main" id="{74C60F2D-85A2-FA73-9062-58000F71392E}"/>
                      </a:ext>
                    </a:extLst>
                  </p:cNvPr>
                  <p:cNvSpPr/>
                  <p:nvPr/>
                </p:nvSpPr>
                <p:spPr>
                  <a:xfrm>
                    <a:off x="4926165" y="2943519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9597EB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70" name="TextBox 25">
                    <a:extLst>
                      <a:ext uri="{FF2B5EF4-FFF2-40B4-BE49-F238E27FC236}">
                        <a16:creationId xmlns:a16="http://schemas.microsoft.com/office/drawing/2014/main" id="{8FA3E243-BBBD-D7DF-E01A-ED5BBF5856F9}"/>
                      </a:ext>
                    </a:extLst>
                  </p:cNvPr>
                  <p:cNvSpPr txBox="1"/>
                  <p:nvPr/>
                </p:nvSpPr>
                <p:spPr>
                  <a:xfrm>
                    <a:off x="4926165" y="2939095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Lack of phycological support to manage the negative emotions experienced by patients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14E534E4-341C-B3A0-1D45-133B8A79F71B}"/>
                    </a:ext>
                  </a:extLst>
                </p:cNvPr>
                <p:cNvGrpSpPr/>
                <p:nvPr/>
              </p:nvGrpSpPr>
              <p:grpSpPr>
                <a:xfrm>
                  <a:off x="4926165" y="3688381"/>
                  <a:ext cx="4404713" cy="684674"/>
                  <a:chOff x="4926165" y="3688414"/>
                  <a:chExt cx="737655" cy="114662"/>
                </a:xfrm>
              </p:grpSpPr>
              <p:sp>
                <p:nvSpPr>
                  <p:cNvPr id="67" name="Freeform 27">
                    <a:extLst>
                      <a:ext uri="{FF2B5EF4-FFF2-40B4-BE49-F238E27FC236}">
                        <a16:creationId xmlns:a16="http://schemas.microsoft.com/office/drawing/2014/main" id="{503EF261-1CE1-4759-0AA9-58B5C4A9F7D7}"/>
                      </a:ext>
                    </a:extLst>
                  </p:cNvPr>
                  <p:cNvSpPr/>
                  <p:nvPr/>
                </p:nvSpPr>
                <p:spPr>
                  <a:xfrm>
                    <a:off x="4926165" y="3688414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AA72D4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68" name="TextBox 28">
                    <a:extLst>
                      <a:ext uri="{FF2B5EF4-FFF2-40B4-BE49-F238E27FC236}">
                        <a16:creationId xmlns:a16="http://schemas.microsoft.com/office/drawing/2014/main" id="{F7F509D1-C8A2-8E90-13EA-E159B4F9775D}"/>
                      </a:ext>
                    </a:extLst>
                  </p:cNvPr>
                  <p:cNvSpPr txBox="1"/>
                  <p:nvPr/>
                </p:nvSpPr>
                <p:spPr>
                  <a:xfrm>
                    <a:off x="4926165" y="3690034"/>
                    <a:ext cx="737655" cy="113042"/>
                  </a:xfrm>
                  <a:prstGeom prst="rect">
                    <a:avLst/>
                  </a:prstGeom>
                  <a:noFill/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Delay of diagnosis, and specialists not with the same level of awareness of disease but also therapies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9051C101-F6BE-7DB5-644D-051CC61B81B1}"/>
                    </a:ext>
                  </a:extLst>
                </p:cNvPr>
                <p:cNvGrpSpPr/>
                <p:nvPr/>
              </p:nvGrpSpPr>
              <p:grpSpPr>
                <a:xfrm>
                  <a:off x="130324" y="1278336"/>
                  <a:ext cx="4404713" cy="680603"/>
                  <a:chOff x="130324" y="1278336"/>
                  <a:chExt cx="737655" cy="113981"/>
                </a:xfrm>
              </p:grpSpPr>
              <p:sp>
                <p:nvSpPr>
                  <p:cNvPr id="65" name="Freeform 30">
                    <a:extLst>
                      <a:ext uri="{FF2B5EF4-FFF2-40B4-BE49-F238E27FC236}">
                        <a16:creationId xmlns:a16="http://schemas.microsoft.com/office/drawing/2014/main" id="{7EEC2C4A-AA6E-C14A-9EE7-0CFA8D59B0F0}"/>
                      </a:ext>
                    </a:extLst>
                  </p:cNvPr>
                  <p:cNvSpPr/>
                  <p:nvPr/>
                </p:nvSpPr>
                <p:spPr>
                  <a:xfrm>
                    <a:off x="130324" y="1286019"/>
                    <a:ext cx="737655" cy="104456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4456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6879"/>
                        </a:lnTo>
                        <a:cubicBezTo>
                          <a:pt x="737655" y="91541"/>
                          <a:pt x="735803" y="96011"/>
                          <a:pt x="732507" y="99308"/>
                        </a:cubicBezTo>
                        <a:cubicBezTo>
                          <a:pt x="729211" y="102604"/>
                          <a:pt x="724740" y="104456"/>
                          <a:pt x="720078" y="104456"/>
                        </a:cubicBezTo>
                        <a:lnTo>
                          <a:pt x="17576" y="104456"/>
                        </a:lnTo>
                        <a:cubicBezTo>
                          <a:pt x="12915" y="104456"/>
                          <a:pt x="8444" y="102604"/>
                          <a:pt x="5148" y="99308"/>
                        </a:cubicBezTo>
                        <a:cubicBezTo>
                          <a:pt x="1852" y="96011"/>
                          <a:pt x="0" y="91541"/>
                          <a:pt x="0" y="86879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A1E1FD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66" name="TextBox 31">
                    <a:extLst>
                      <a:ext uri="{FF2B5EF4-FFF2-40B4-BE49-F238E27FC236}">
                        <a16:creationId xmlns:a16="http://schemas.microsoft.com/office/drawing/2014/main" id="{C0A2036C-68CC-5195-2075-8E21551C7B2A}"/>
                      </a:ext>
                    </a:extLst>
                  </p:cNvPr>
                  <p:cNvSpPr txBox="1"/>
                  <p:nvPr/>
                </p:nvSpPr>
                <p:spPr>
                  <a:xfrm>
                    <a:off x="130324" y="1278336"/>
                    <a:ext cx="737655" cy="113981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Lack of </a:t>
                    </a:r>
                    <a:r>
                      <a:rPr lang="en-GB" sz="900" b="1" kern="1200">
                        <a:solidFill>
                          <a:srgbClr val="4E51DE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management of comorbidities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Need to increase patients networking and referral to PAGs.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E4BE4FF7-7DDE-1575-112B-2198337B2939}"/>
                    </a:ext>
                  </a:extLst>
                </p:cNvPr>
                <p:cNvGrpSpPr/>
                <p:nvPr/>
              </p:nvGrpSpPr>
              <p:grpSpPr>
                <a:xfrm>
                  <a:off x="70677" y="2015847"/>
                  <a:ext cx="4464360" cy="910230"/>
                  <a:chOff x="70677" y="2015847"/>
                  <a:chExt cx="747644" cy="152437"/>
                </a:xfrm>
              </p:grpSpPr>
              <p:sp>
                <p:nvSpPr>
                  <p:cNvPr id="63" name="Freeform 33">
                    <a:extLst>
                      <a:ext uri="{FF2B5EF4-FFF2-40B4-BE49-F238E27FC236}">
                        <a16:creationId xmlns:a16="http://schemas.microsoft.com/office/drawing/2014/main" id="{94CC6D6D-D6C1-290B-3716-4E2FE0089F20}"/>
                      </a:ext>
                    </a:extLst>
                  </p:cNvPr>
                  <p:cNvSpPr/>
                  <p:nvPr/>
                </p:nvSpPr>
                <p:spPr>
                  <a:xfrm>
                    <a:off x="80666" y="2015847"/>
                    <a:ext cx="737655" cy="140416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40416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122839"/>
                        </a:lnTo>
                        <a:cubicBezTo>
                          <a:pt x="737655" y="127501"/>
                          <a:pt x="735803" y="131971"/>
                          <a:pt x="732507" y="135268"/>
                        </a:cubicBezTo>
                        <a:cubicBezTo>
                          <a:pt x="729211" y="138564"/>
                          <a:pt x="724740" y="140416"/>
                          <a:pt x="720078" y="140416"/>
                        </a:cubicBezTo>
                        <a:lnTo>
                          <a:pt x="17576" y="140416"/>
                        </a:lnTo>
                        <a:cubicBezTo>
                          <a:pt x="12915" y="140416"/>
                          <a:pt x="8444" y="138564"/>
                          <a:pt x="5148" y="135268"/>
                        </a:cubicBezTo>
                        <a:cubicBezTo>
                          <a:pt x="1852" y="131971"/>
                          <a:pt x="0" y="127501"/>
                          <a:pt x="0" y="122839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85B8FB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64" name="TextBox 34">
                    <a:extLst>
                      <a:ext uri="{FF2B5EF4-FFF2-40B4-BE49-F238E27FC236}">
                        <a16:creationId xmlns:a16="http://schemas.microsoft.com/office/drawing/2014/main" id="{001F30FF-2F9E-1357-16D2-367646BB4375}"/>
                      </a:ext>
                    </a:extLst>
                  </p:cNvPr>
                  <p:cNvSpPr txBox="1"/>
                  <p:nvPr/>
                </p:nvSpPr>
                <p:spPr>
                  <a:xfrm>
                    <a:off x="70677" y="2018343"/>
                    <a:ext cx="737655" cy="149941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Health inequalities within EU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3" name="Group 42">
                  <a:extLst>
                    <a:ext uri="{FF2B5EF4-FFF2-40B4-BE49-F238E27FC236}">
                      <a16:creationId xmlns:a16="http://schemas.microsoft.com/office/drawing/2014/main" id="{96E9D250-9262-1054-317B-128C79424CCD}"/>
                    </a:ext>
                  </a:extLst>
                </p:cNvPr>
                <p:cNvGrpSpPr/>
                <p:nvPr/>
              </p:nvGrpSpPr>
              <p:grpSpPr>
                <a:xfrm>
                  <a:off x="130324" y="2950024"/>
                  <a:ext cx="4404713" cy="674998"/>
                  <a:chOff x="130324" y="2950024"/>
                  <a:chExt cx="737655" cy="113042"/>
                </a:xfrm>
              </p:grpSpPr>
              <p:sp>
                <p:nvSpPr>
                  <p:cNvPr id="61" name="Freeform 36">
                    <a:extLst>
                      <a:ext uri="{FF2B5EF4-FFF2-40B4-BE49-F238E27FC236}">
                        <a16:creationId xmlns:a16="http://schemas.microsoft.com/office/drawing/2014/main" id="{4AE29E58-E889-D917-F579-85F53C1A7A41}"/>
                      </a:ext>
                    </a:extLst>
                  </p:cNvPr>
                  <p:cNvSpPr/>
                  <p:nvPr/>
                </p:nvSpPr>
                <p:spPr>
                  <a:xfrm>
                    <a:off x="130324" y="2952619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9597EB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62" name="TextBox 37">
                    <a:extLst>
                      <a:ext uri="{FF2B5EF4-FFF2-40B4-BE49-F238E27FC236}">
                        <a16:creationId xmlns:a16="http://schemas.microsoft.com/office/drawing/2014/main" id="{398A1800-B8C9-73EF-AB4A-B19AD2C87BA6}"/>
                      </a:ext>
                    </a:extLst>
                  </p:cNvPr>
                  <p:cNvSpPr txBox="1"/>
                  <p:nvPr/>
                </p:nvSpPr>
                <p:spPr>
                  <a:xfrm>
                    <a:off x="130324" y="2950024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Underestimation of burden of disease by society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35C66B7B-199E-F90C-38C8-7BC05CFD70C9}"/>
                    </a:ext>
                  </a:extLst>
                </p:cNvPr>
                <p:cNvGrpSpPr/>
                <p:nvPr/>
              </p:nvGrpSpPr>
              <p:grpSpPr>
                <a:xfrm>
                  <a:off x="130324" y="3672906"/>
                  <a:ext cx="4404713" cy="674998"/>
                  <a:chOff x="130324" y="3672906"/>
                  <a:chExt cx="737655" cy="113042"/>
                </a:xfrm>
              </p:grpSpPr>
              <p:sp>
                <p:nvSpPr>
                  <p:cNvPr id="59" name="Freeform 39">
                    <a:extLst>
                      <a:ext uri="{FF2B5EF4-FFF2-40B4-BE49-F238E27FC236}">
                        <a16:creationId xmlns:a16="http://schemas.microsoft.com/office/drawing/2014/main" id="{7A4A683C-0670-33B1-18E9-6C298CA6F2DA}"/>
                      </a:ext>
                    </a:extLst>
                  </p:cNvPr>
                  <p:cNvSpPr/>
                  <p:nvPr/>
                </p:nvSpPr>
                <p:spPr>
                  <a:xfrm>
                    <a:off x="130324" y="3675505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AA72D4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60" name="TextBox 40">
                    <a:extLst>
                      <a:ext uri="{FF2B5EF4-FFF2-40B4-BE49-F238E27FC236}">
                        <a16:creationId xmlns:a16="http://schemas.microsoft.com/office/drawing/2014/main" id="{47C62B1D-134B-A031-84E3-C52597251B4F}"/>
                      </a:ext>
                    </a:extLst>
                  </p:cNvPr>
                  <p:cNvSpPr txBox="1"/>
                  <p:nvPr/>
                </p:nvSpPr>
                <p:spPr>
                  <a:xfrm>
                    <a:off x="130324" y="3672906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Lack of knowledge of the condition by health care providers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5" name="TextBox 41">
                  <a:extLst>
                    <a:ext uri="{FF2B5EF4-FFF2-40B4-BE49-F238E27FC236}">
                      <a16:creationId xmlns:a16="http://schemas.microsoft.com/office/drawing/2014/main" id="{6ABA5AE4-E130-9DF3-31C2-63F38C846E6A}"/>
                    </a:ext>
                  </a:extLst>
                </p:cNvPr>
                <p:cNvSpPr txBox="1"/>
                <p:nvPr/>
              </p:nvSpPr>
              <p:spPr>
                <a:xfrm>
                  <a:off x="589467" y="72600"/>
                  <a:ext cx="3486044" cy="476453"/>
                </a:xfrm>
                <a:prstGeom prst="rect">
                  <a:avLst/>
                </a:prstGeom>
              </p:spPr>
              <p:txBody>
                <a:bodyPr wrap="square" lIns="0" tIns="0" rIns="0" bIns="0" rtlCol="0" anchor="t"/>
                <a:lstStyle/>
                <a:p>
                  <a:pPr algn="ctr">
                    <a:lnSpc>
                      <a:spcPts val="1470"/>
                    </a:lnSpc>
                    <a:spcAft>
                      <a:spcPts val="800"/>
                    </a:spcAft>
                    <a:buNone/>
                  </a:pPr>
                  <a:r>
                    <a:rPr lang="en-GB" sz="900" kern="1200">
                      <a:solidFill>
                        <a:srgbClr val="000000"/>
                      </a:solidFill>
                      <a:effectLst/>
                      <a:latin typeface="DM Sans Bold" pitchFamily="2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Shortcomings of current CRSwNP care presented by EUFOREA</a:t>
                  </a:r>
                  <a:endParaRPr lang="it-IT" sz="11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42">
                  <a:extLst>
                    <a:ext uri="{FF2B5EF4-FFF2-40B4-BE49-F238E27FC236}">
                      <a16:creationId xmlns:a16="http://schemas.microsoft.com/office/drawing/2014/main" id="{FFEA68BD-92EA-EB2E-5A3A-CD87685523E7}"/>
                    </a:ext>
                  </a:extLst>
                </p:cNvPr>
                <p:cNvSpPr txBox="1"/>
                <p:nvPr/>
              </p:nvSpPr>
              <p:spPr>
                <a:xfrm>
                  <a:off x="5384969" y="162924"/>
                  <a:ext cx="3486044" cy="289184"/>
                </a:xfrm>
                <a:prstGeom prst="rect">
                  <a:avLst/>
                </a:prstGeom>
              </p:spPr>
              <p:txBody>
                <a:bodyPr wrap="square" lIns="0" tIns="0" rIns="0" bIns="0" rtlCol="0" anchor="t"/>
                <a:lstStyle/>
                <a:p>
                  <a:pPr algn="ctr">
                    <a:lnSpc>
                      <a:spcPts val="1470"/>
                    </a:lnSpc>
                    <a:spcAft>
                      <a:spcPts val="800"/>
                    </a:spcAft>
                    <a:buNone/>
                  </a:pPr>
                  <a:r>
                    <a:rPr lang="en-GB" sz="900" kern="1200">
                      <a:solidFill>
                        <a:srgbClr val="000000"/>
                      </a:solidFill>
                      <a:effectLst/>
                      <a:latin typeface="DM Sans Bold" pitchFamily="2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Results of the Italian Board analysis</a:t>
                  </a:r>
                  <a:endParaRPr lang="it-IT" sz="11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7" name="Group 46">
                  <a:extLst>
                    <a:ext uri="{FF2B5EF4-FFF2-40B4-BE49-F238E27FC236}">
                      <a16:creationId xmlns:a16="http://schemas.microsoft.com/office/drawing/2014/main" id="{D32F2E0B-D32A-E33E-5673-DF07B40AF273}"/>
                    </a:ext>
                  </a:extLst>
                </p:cNvPr>
                <p:cNvGrpSpPr/>
                <p:nvPr/>
              </p:nvGrpSpPr>
              <p:grpSpPr>
                <a:xfrm>
                  <a:off x="130324" y="4395785"/>
                  <a:ext cx="4404713" cy="674998"/>
                  <a:chOff x="130324" y="4395785"/>
                  <a:chExt cx="737655" cy="113042"/>
                </a:xfrm>
              </p:grpSpPr>
              <p:sp>
                <p:nvSpPr>
                  <p:cNvPr id="57" name="Freeform 44">
                    <a:extLst>
                      <a:ext uri="{FF2B5EF4-FFF2-40B4-BE49-F238E27FC236}">
                        <a16:creationId xmlns:a16="http://schemas.microsoft.com/office/drawing/2014/main" id="{82FA45D2-3E49-12B1-A0DC-6CE06CC8B989}"/>
                      </a:ext>
                    </a:extLst>
                  </p:cNvPr>
                  <p:cNvSpPr/>
                  <p:nvPr/>
                </p:nvSpPr>
                <p:spPr>
                  <a:xfrm>
                    <a:off x="130324" y="4403472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FBFFFF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58" name="TextBox 45">
                    <a:extLst>
                      <a:ext uri="{FF2B5EF4-FFF2-40B4-BE49-F238E27FC236}">
                        <a16:creationId xmlns:a16="http://schemas.microsoft.com/office/drawing/2014/main" id="{3321E527-7B54-3BA8-CD2D-E101868F9935}"/>
                      </a:ext>
                    </a:extLst>
                  </p:cNvPr>
                  <p:cNvSpPr txBox="1"/>
                  <p:nvPr/>
                </p:nvSpPr>
                <p:spPr>
                  <a:xfrm>
                    <a:off x="130324" y="4395785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Limited treatment options, with limited access to novel treatments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8" name="Group 47">
                  <a:extLst>
                    <a:ext uri="{FF2B5EF4-FFF2-40B4-BE49-F238E27FC236}">
                      <a16:creationId xmlns:a16="http://schemas.microsoft.com/office/drawing/2014/main" id="{F6C7483A-D499-3C7B-EBD2-BE2B0C0BE58D}"/>
                    </a:ext>
                  </a:extLst>
                </p:cNvPr>
                <p:cNvGrpSpPr/>
                <p:nvPr/>
              </p:nvGrpSpPr>
              <p:grpSpPr>
                <a:xfrm>
                  <a:off x="4926165" y="4323991"/>
                  <a:ext cx="4404713" cy="735810"/>
                  <a:chOff x="4926165" y="4323991"/>
                  <a:chExt cx="737655" cy="123226"/>
                </a:xfrm>
              </p:grpSpPr>
              <p:sp>
                <p:nvSpPr>
                  <p:cNvPr id="55" name="Freeform 47">
                    <a:extLst>
                      <a:ext uri="{FF2B5EF4-FFF2-40B4-BE49-F238E27FC236}">
                        <a16:creationId xmlns:a16="http://schemas.microsoft.com/office/drawing/2014/main" id="{031A6E7C-ACF0-3935-EC8A-8A0848A2DB5A}"/>
                      </a:ext>
                    </a:extLst>
                  </p:cNvPr>
                  <p:cNvSpPr/>
                  <p:nvPr/>
                </p:nvSpPr>
                <p:spPr>
                  <a:xfrm>
                    <a:off x="4926165" y="4343700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FBFFFF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56" name="TextBox 48">
                    <a:extLst>
                      <a:ext uri="{FF2B5EF4-FFF2-40B4-BE49-F238E27FC236}">
                        <a16:creationId xmlns:a16="http://schemas.microsoft.com/office/drawing/2014/main" id="{49B0AD9B-8299-1A71-9CB7-4639F0A23B26}"/>
                      </a:ext>
                    </a:extLst>
                  </p:cNvPr>
                  <p:cNvSpPr txBox="1"/>
                  <p:nvPr/>
                </p:nvSpPr>
                <p:spPr>
                  <a:xfrm>
                    <a:off x="4926165" y="4323991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Topic not addressed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DE9BD225-2E37-6B3E-C7B1-13770D25B421}"/>
                    </a:ext>
                  </a:extLst>
                </p:cNvPr>
                <p:cNvGrpSpPr/>
                <p:nvPr/>
              </p:nvGrpSpPr>
              <p:grpSpPr>
                <a:xfrm>
                  <a:off x="130324" y="5118667"/>
                  <a:ext cx="4404713" cy="674998"/>
                  <a:chOff x="130324" y="5118667"/>
                  <a:chExt cx="737655" cy="113042"/>
                </a:xfrm>
              </p:grpSpPr>
              <p:sp>
                <p:nvSpPr>
                  <p:cNvPr id="53" name="Freeform 50">
                    <a:extLst>
                      <a:ext uri="{FF2B5EF4-FFF2-40B4-BE49-F238E27FC236}">
                        <a16:creationId xmlns:a16="http://schemas.microsoft.com/office/drawing/2014/main" id="{BAF069B2-32A0-A5B5-3186-DF4179BC2712}"/>
                      </a:ext>
                    </a:extLst>
                  </p:cNvPr>
                  <p:cNvSpPr/>
                  <p:nvPr/>
                </p:nvSpPr>
                <p:spPr>
                  <a:xfrm>
                    <a:off x="130324" y="5126350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FBFFFF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54" name="TextBox 51">
                    <a:extLst>
                      <a:ext uri="{FF2B5EF4-FFF2-40B4-BE49-F238E27FC236}">
                        <a16:creationId xmlns:a16="http://schemas.microsoft.com/office/drawing/2014/main" id="{6C1DB3B8-979E-48B2-9B5C-7A34A93BD6CE}"/>
                      </a:ext>
                    </a:extLst>
                  </p:cNvPr>
                  <p:cNvSpPr txBox="1"/>
                  <p:nvPr/>
                </p:nvSpPr>
                <p:spPr>
                  <a:xfrm>
                    <a:off x="130324" y="5118667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Lack of personalized care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0" name="Group 49">
                  <a:extLst>
                    <a:ext uri="{FF2B5EF4-FFF2-40B4-BE49-F238E27FC236}">
                      <a16:creationId xmlns:a16="http://schemas.microsoft.com/office/drawing/2014/main" id="{C5E764B3-1EBA-6948-EEFF-7FBFD65B9247}"/>
                    </a:ext>
                  </a:extLst>
                </p:cNvPr>
                <p:cNvGrpSpPr/>
                <p:nvPr/>
              </p:nvGrpSpPr>
              <p:grpSpPr>
                <a:xfrm>
                  <a:off x="4926165" y="5046885"/>
                  <a:ext cx="4404713" cy="735834"/>
                  <a:chOff x="4926165" y="5046885"/>
                  <a:chExt cx="737655" cy="123230"/>
                </a:xfrm>
              </p:grpSpPr>
              <p:sp>
                <p:nvSpPr>
                  <p:cNvPr id="51" name="Freeform 53">
                    <a:extLst>
                      <a:ext uri="{FF2B5EF4-FFF2-40B4-BE49-F238E27FC236}">
                        <a16:creationId xmlns:a16="http://schemas.microsoft.com/office/drawing/2014/main" id="{68C912CD-FC16-E304-7301-75D34AC58C0E}"/>
                      </a:ext>
                    </a:extLst>
                  </p:cNvPr>
                  <p:cNvSpPr/>
                  <p:nvPr/>
                </p:nvSpPr>
                <p:spPr>
                  <a:xfrm>
                    <a:off x="4926165" y="5066598"/>
                    <a:ext cx="737655" cy="103517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37655" h="103517">
                        <a:moveTo>
                          <a:pt x="17576" y="0"/>
                        </a:moveTo>
                        <a:lnTo>
                          <a:pt x="720078" y="0"/>
                        </a:lnTo>
                        <a:cubicBezTo>
                          <a:pt x="729786" y="0"/>
                          <a:pt x="737655" y="7869"/>
                          <a:pt x="737655" y="17576"/>
                        </a:cubicBezTo>
                        <a:lnTo>
                          <a:pt x="737655" y="85941"/>
                        </a:lnTo>
                        <a:cubicBezTo>
                          <a:pt x="737655" y="90602"/>
                          <a:pt x="735803" y="95073"/>
                          <a:pt x="732507" y="98369"/>
                        </a:cubicBezTo>
                        <a:cubicBezTo>
                          <a:pt x="729211" y="101665"/>
                          <a:pt x="724740" y="103517"/>
                          <a:pt x="720078" y="103517"/>
                        </a:cubicBezTo>
                        <a:lnTo>
                          <a:pt x="17576" y="103517"/>
                        </a:lnTo>
                        <a:cubicBezTo>
                          <a:pt x="12915" y="103517"/>
                          <a:pt x="8444" y="101665"/>
                          <a:pt x="5148" y="98369"/>
                        </a:cubicBezTo>
                        <a:cubicBezTo>
                          <a:pt x="1852" y="95073"/>
                          <a:pt x="0" y="90602"/>
                          <a:pt x="0" y="85941"/>
                        </a:cubicBezTo>
                        <a:lnTo>
                          <a:pt x="0" y="17576"/>
                        </a:lnTo>
                        <a:cubicBezTo>
                          <a:pt x="0" y="12915"/>
                          <a:pt x="1852" y="8444"/>
                          <a:pt x="5148" y="5148"/>
                        </a:cubicBezTo>
                        <a:cubicBezTo>
                          <a:pt x="8444" y="1852"/>
                          <a:pt x="12915" y="0"/>
                          <a:pt x="17576" y="0"/>
                        </a:cubicBezTo>
                        <a:close/>
                      </a:path>
                    </a:pathLst>
                  </a:custGeom>
                  <a:solidFill>
                    <a:srgbClr val="FBFFFF"/>
                  </a:solidFill>
                </p:spPr>
                <p:txBody>
                  <a:bodyPr/>
                  <a:lstStyle/>
                  <a:p>
                    <a:endParaRPr lang="it-IT"/>
                  </a:p>
                </p:txBody>
              </p:sp>
              <p:sp>
                <p:nvSpPr>
                  <p:cNvPr id="52" name="TextBox 54">
                    <a:extLst>
                      <a:ext uri="{FF2B5EF4-FFF2-40B4-BE49-F238E27FC236}">
                        <a16:creationId xmlns:a16="http://schemas.microsoft.com/office/drawing/2014/main" id="{7F888844-0D1F-1811-B37E-3A666BD02CF5}"/>
                      </a:ext>
                    </a:extLst>
                  </p:cNvPr>
                  <p:cNvSpPr txBox="1"/>
                  <p:nvPr/>
                </p:nvSpPr>
                <p:spPr>
                  <a:xfrm>
                    <a:off x="4926165" y="5046885"/>
                    <a:ext cx="737655" cy="113042"/>
                  </a:xfrm>
                  <a:prstGeom prst="rect">
                    <a:avLst/>
                  </a:prstGeom>
                </p:spPr>
                <p:txBody>
                  <a:bodyPr lIns="127000" tIns="127000" rIns="127000" bIns="127000" rtlCol="0" anchor="ctr"/>
                  <a:lstStyle/>
                  <a:p>
                    <a:pPr algn="ctr">
                      <a:lnSpc>
                        <a:spcPts val="1200"/>
                      </a:lnSpc>
                      <a:spcAft>
                        <a:spcPts val="800"/>
                      </a:spcAft>
                      <a:buNone/>
                    </a:pPr>
                    <a:r>
                      <a:rPr lang="en-GB" sz="900" kern="1200">
                        <a:solidFill>
                          <a:srgbClr val="000000"/>
                        </a:solidFill>
                        <a:effectLst/>
                        <a:latin typeface="DM Sans" pitchFamily="2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Topic not addressed</a:t>
                    </a:r>
                    <a:endParaRPr lang="it-IT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1933866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ea66b2b-af80-48b6-873b-d341d3035cfa}" enabled="1" method="Standard" siteId="{63982aff-fb6c-4c22-973b-70e4acfb63e6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27</Words>
  <Application>Microsoft Office PowerPoint</Application>
  <PresentationFormat>Custom</PresentationFormat>
  <Paragraphs>7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GSK Precision</vt:lpstr>
      <vt:lpstr>Aptos</vt:lpstr>
      <vt:lpstr>DM Sans</vt:lpstr>
      <vt:lpstr>Calibri Light</vt:lpstr>
      <vt:lpstr>Arial</vt:lpstr>
      <vt:lpstr>Calibri</vt:lpstr>
      <vt:lpstr>DM Sans Bold</vt:lpstr>
      <vt:lpstr>Canva Sans 1 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ss of sense of smell, alteration in smell and/or taste perception</dc:title>
  <dc:creator>Lara Bernardi</dc:creator>
  <cp:lastModifiedBy>Lara Bernardi</cp:lastModifiedBy>
  <cp:revision>3</cp:revision>
  <dcterms:created xsi:type="dcterms:W3CDTF">2006-08-16T00:00:00Z</dcterms:created>
  <dcterms:modified xsi:type="dcterms:W3CDTF">2025-10-15T09:32:09Z</dcterms:modified>
  <dc:identifier>DAGClJYS8LA</dc:identifier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a66b2b-af80-48b6-873b-d341d3035cfa_Enabled">
    <vt:lpwstr>true</vt:lpwstr>
  </property>
  <property fmtid="{D5CDD505-2E9C-101B-9397-08002B2CF9AE}" pid="3" name="MSIP_Label_bea66b2b-af80-48b6-873b-d341d3035cfa_SetDate">
    <vt:lpwstr>2024-10-23T07:13:01Z</vt:lpwstr>
  </property>
  <property fmtid="{D5CDD505-2E9C-101B-9397-08002B2CF9AE}" pid="4" name="MSIP_Label_bea66b2b-af80-48b6-873b-d341d3035cfa_Method">
    <vt:lpwstr>Standard</vt:lpwstr>
  </property>
  <property fmtid="{D5CDD505-2E9C-101B-9397-08002B2CF9AE}" pid="5" name="MSIP_Label_bea66b2b-af80-48b6-873b-d341d3035cfa_Name">
    <vt:lpwstr>Proprietary</vt:lpwstr>
  </property>
  <property fmtid="{D5CDD505-2E9C-101B-9397-08002B2CF9AE}" pid="6" name="MSIP_Label_bea66b2b-af80-48b6-873b-d341d3035cfa_SiteId">
    <vt:lpwstr>63982aff-fb6c-4c22-973b-70e4acfb63e6</vt:lpwstr>
  </property>
  <property fmtid="{D5CDD505-2E9C-101B-9397-08002B2CF9AE}" pid="7" name="MSIP_Label_bea66b2b-af80-48b6-873b-d341d3035cfa_ActionId">
    <vt:lpwstr>4ddb8b1e-a069-4ca0-89eb-0037e92e605f</vt:lpwstr>
  </property>
  <property fmtid="{D5CDD505-2E9C-101B-9397-08002B2CF9AE}" pid="8" name="MSIP_Label_bea66b2b-af80-48b6-873b-d341d3035cfa_ContentBits">
    <vt:lpwstr>0</vt:lpwstr>
  </property>
</Properties>
</file>